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  <p:sldId id="256" r:id="rId3"/>
    <p:sldId id="275" r:id="rId4"/>
    <p:sldId id="272" r:id="rId5"/>
    <p:sldId id="276" r:id="rId6"/>
  </p:sldIdLst>
  <p:sldSz cx="6858000" cy="9906000" type="A4"/>
  <p:notesSz cx="6761163" cy="99425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69" userDrawn="1">
          <p15:clr>
            <a:srgbClr val="A4A3A4"/>
          </p15:clr>
        </p15:guide>
        <p15:guide id="2" pos="286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dia Rucci" initials="NR" lastIdx="6" clrIdx="0">
    <p:extLst>
      <p:ext uri="{19B8F6BF-5375-455C-9EA6-DF929625EA0E}">
        <p15:presenceInfo xmlns:p15="http://schemas.microsoft.com/office/powerpoint/2012/main" userId="S::nadia.rucci@univaq.it::4ac8485d-950c-49b0-a4fa-24725471f0c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4" autoAdjust="0"/>
    <p:restoredTop sz="94660"/>
  </p:normalViewPr>
  <p:slideViewPr>
    <p:cSldViewPr snapToGrid="0" showGuides="1">
      <p:cViewPr>
        <p:scale>
          <a:sx n="400" d="100"/>
          <a:sy n="400" d="100"/>
        </p:scale>
        <p:origin x="-2058" y="-7362"/>
      </p:cViewPr>
      <p:guideLst>
        <p:guide orient="horz" pos="1669"/>
        <p:guide pos="2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emf"/><Relationship Id="rId1" Type="http://schemas.openxmlformats.org/officeDocument/2006/relationships/image" Target="../media/image35.emf"/><Relationship Id="rId4" Type="http://schemas.openxmlformats.org/officeDocument/2006/relationships/image" Target="../media/image38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image" Target="../media/image40.emf"/><Relationship Id="rId1" Type="http://schemas.openxmlformats.org/officeDocument/2006/relationships/image" Target="../media/image39.emf"/><Relationship Id="rId4" Type="http://schemas.openxmlformats.org/officeDocument/2006/relationships/image" Target="../media/image4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911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7750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79866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2842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9288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382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7489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1219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8304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85654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4785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C5569-2783-49FC-B860-F4301DCB6116}" type="datetimeFigureOut">
              <a:rPr lang="it-IT" smtClean="0"/>
              <a:t>06/0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C0B567-7331-4192-A170-7CDAB24DEBD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0258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13.png"/><Relationship Id="rId26" Type="http://schemas.openxmlformats.org/officeDocument/2006/relationships/image" Target="../media/image17.png"/><Relationship Id="rId21" Type="http://schemas.microsoft.com/office/2007/relationships/hdphoto" Target="../media/hdphoto10.wdp"/><Relationship Id="rId34" Type="http://schemas.openxmlformats.org/officeDocument/2006/relationships/image" Target="../media/image21.png"/><Relationship Id="rId7" Type="http://schemas.microsoft.com/office/2007/relationships/hdphoto" Target="../media/hdphoto3.wdp"/><Relationship Id="rId12" Type="http://schemas.openxmlformats.org/officeDocument/2006/relationships/image" Target="../media/image10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2" Type="http://schemas.openxmlformats.org/officeDocument/2006/relationships/image" Target="../media/image5.png"/><Relationship Id="rId16" Type="http://schemas.openxmlformats.org/officeDocument/2006/relationships/image" Target="../media/image12.png"/><Relationship Id="rId20" Type="http://schemas.openxmlformats.org/officeDocument/2006/relationships/image" Target="../media/image14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microsoft.com/office/2007/relationships/hdphoto" Target="../media/hdphoto5.wdp"/><Relationship Id="rId24" Type="http://schemas.openxmlformats.org/officeDocument/2006/relationships/image" Target="../media/image16.png"/><Relationship Id="rId32" Type="http://schemas.openxmlformats.org/officeDocument/2006/relationships/image" Target="../media/image20.png"/><Relationship Id="rId37" Type="http://schemas.microsoft.com/office/2007/relationships/hdphoto" Target="../media/hdphoto18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8.png"/><Relationship Id="rId36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" Type="http://schemas.openxmlformats.org/officeDocument/2006/relationships/image" Target="../media/image6.png"/><Relationship Id="rId9" Type="http://schemas.microsoft.com/office/2007/relationships/hdphoto" Target="../media/hdphoto4.wdp"/><Relationship Id="rId14" Type="http://schemas.openxmlformats.org/officeDocument/2006/relationships/image" Target="../media/image11.png"/><Relationship Id="rId22" Type="http://schemas.openxmlformats.org/officeDocument/2006/relationships/image" Target="../media/image15.png"/><Relationship Id="rId27" Type="http://schemas.microsoft.com/office/2007/relationships/hdphoto" Target="../media/hdphoto13.wdp"/><Relationship Id="rId30" Type="http://schemas.openxmlformats.org/officeDocument/2006/relationships/image" Target="../media/image19.png"/><Relationship Id="rId35" Type="http://schemas.microsoft.com/office/2007/relationships/hdphoto" Target="../media/hdphoto17.wdp"/><Relationship Id="rId8" Type="http://schemas.openxmlformats.org/officeDocument/2006/relationships/image" Target="../media/image8.png"/><Relationship Id="rId3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microsoft.com/office/2007/relationships/hdphoto" Target="../media/hdphoto24.wdp"/><Relationship Id="rId18" Type="http://schemas.openxmlformats.org/officeDocument/2006/relationships/image" Target="../media/image31.jpeg"/><Relationship Id="rId3" Type="http://schemas.microsoft.com/office/2007/relationships/hdphoto" Target="../media/hdphoto19.wdp"/><Relationship Id="rId21" Type="http://schemas.openxmlformats.org/officeDocument/2006/relationships/image" Target="../media/image33.png"/><Relationship Id="rId7" Type="http://schemas.microsoft.com/office/2007/relationships/hdphoto" Target="../media/hdphoto21.wdp"/><Relationship Id="rId12" Type="http://schemas.openxmlformats.org/officeDocument/2006/relationships/image" Target="../media/image28.png"/><Relationship Id="rId17" Type="http://schemas.microsoft.com/office/2007/relationships/hdphoto" Target="../media/hdphoto26.wdp"/><Relationship Id="rId2" Type="http://schemas.openxmlformats.org/officeDocument/2006/relationships/image" Target="../media/image23.png"/><Relationship Id="rId16" Type="http://schemas.openxmlformats.org/officeDocument/2006/relationships/image" Target="../media/image30.png"/><Relationship Id="rId20" Type="http://schemas.microsoft.com/office/2007/relationships/hdphoto" Target="../media/hdphoto27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11" Type="http://schemas.microsoft.com/office/2007/relationships/hdphoto" Target="../media/hdphoto23.wdp"/><Relationship Id="rId24" Type="http://schemas.microsoft.com/office/2007/relationships/hdphoto" Target="../media/hdphoto29.wdp"/><Relationship Id="rId5" Type="http://schemas.microsoft.com/office/2007/relationships/hdphoto" Target="../media/hdphoto20.wdp"/><Relationship Id="rId15" Type="http://schemas.microsoft.com/office/2007/relationships/hdphoto" Target="../media/hdphoto25.wdp"/><Relationship Id="rId23" Type="http://schemas.openxmlformats.org/officeDocument/2006/relationships/image" Target="../media/image34.png"/><Relationship Id="rId10" Type="http://schemas.openxmlformats.org/officeDocument/2006/relationships/image" Target="../media/image27.png"/><Relationship Id="rId19" Type="http://schemas.openxmlformats.org/officeDocument/2006/relationships/image" Target="../media/image32.png"/><Relationship Id="rId4" Type="http://schemas.openxmlformats.org/officeDocument/2006/relationships/image" Target="../media/image24.png"/><Relationship Id="rId9" Type="http://schemas.microsoft.com/office/2007/relationships/hdphoto" Target="../media/hdphoto22.wdp"/><Relationship Id="rId14" Type="http://schemas.openxmlformats.org/officeDocument/2006/relationships/image" Target="../media/image29.png"/><Relationship Id="rId22" Type="http://schemas.microsoft.com/office/2007/relationships/hdphoto" Target="../media/hdphoto28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e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6.emf"/><Relationship Id="rId5" Type="http://schemas.openxmlformats.org/officeDocument/2006/relationships/oleObject" Target="../embeddings/oleObject6.bin"/><Relationship Id="rId10" Type="http://schemas.openxmlformats.org/officeDocument/2006/relationships/image" Target="../media/image38.emf"/><Relationship Id="rId4" Type="http://schemas.openxmlformats.org/officeDocument/2006/relationships/image" Target="../media/image35.emf"/><Relationship Id="rId9" Type="http://schemas.openxmlformats.org/officeDocument/2006/relationships/oleObject" Target="../embeddings/oleObject8.bin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0.wdp"/><Relationship Id="rId13" Type="http://schemas.openxmlformats.org/officeDocument/2006/relationships/oleObject" Target="../embeddings/oleObject11.bin"/><Relationship Id="rId18" Type="http://schemas.microsoft.com/office/2007/relationships/hdphoto" Target="../media/hdphoto34.wdp"/><Relationship Id="rId3" Type="http://schemas.openxmlformats.org/officeDocument/2006/relationships/oleObject" Target="../embeddings/oleObject9.bin"/><Relationship Id="rId21" Type="http://schemas.openxmlformats.org/officeDocument/2006/relationships/oleObject" Target="../embeddings/oleObject12.bin"/><Relationship Id="rId7" Type="http://schemas.openxmlformats.org/officeDocument/2006/relationships/image" Target="../media/image43.png"/><Relationship Id="rId12" Type="http://schemas.microsoft.com/office/2007/relationships/hdphoto" Target="../media/hdphoto32.wdp"/><Relationship Id="rId17" Type="http://schemas.openxmlformats.org/officeDocument/2006/relationships/image" Target="../media/image47.png"/><Relationship Id="rId2" Type="http://schemas.openxmlformats.org/officeDocument/2006/relationships/slideLayout" Target="../slideLayouts/slideLayout2.xml"/><Relationship Id="rId16" Type="http://schemas.microsoft.com/office/2007/relationships/hdphoto" Target="../media/hdphoto33.wdp"/><Relationship Id="rId20" Type="http://schemas.microsoft.com/office/2007/relationships/hdphoto" Target="../media/hdphoto35.wdp"/><Relationship Id="rId1" Type="http://schemas.openxmlformats.org/officeDocument/2006/relationships/vmlDrawing" Target="../drawings/vmlDrawing3.vml"/><Relationship Id="rId6" Type="http://schemas.openxmlformats.org/officeDocument/2006/relationships/image" Target="../media/image40.emf"/><Relationship Id="rId11" Type="http://schemas.openxmlformats.org/officeDocument/2006/relationships/image" Target="../media/image45.png"/><Relationship Id="rId5" Type="http://schemas.openxmlformats.org/officeDocument/2006/relationships/oleObject" Target="../embeddings/oleObject10.bin"/><Relationship Id="rId15" Type="http://schemas.openxmlformats.org/officeDocument/2006/relationships/image" Target="../media/image46.png"/><Relationship Id="rId10" Type="http://schemas.microsoft.com/office/2007/relationships/hdphoto" Target="../media/hdphoto31.wdp"/><Relationship Id="rId19" Type="http://schemas.openxmlformats.org/officeDocument/2006/relationships/image" Target="../media/image48.png"/><Relationship Id="rId4" Type="http://schemas.openxmlformats.org/officeDocument/2006/relationships/image" Target="../media/image39.emf"/><Relationship Id="rId9" Type="http://schemas.openxmlformats.org/officeDocument/2006/relationships/image" Target="../media/image44.png"/><Relationship Id="rId14" Type="http://schemas.openxmlformats.org/officeDocument/2006/relationships/image" Target="../media/image41.emf"/><Relationship Id="rId22" Type="http://schemas.openxmlformats.org/officeDocument/2006/relationships/image" Target="../media/image4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8A8E12A0-C1AF-4B9C-B124-7F7689FE1F19}"/>
              </a:ext>
            </a:extLst>
          </p:cNvPr>
          <p:cNvGrpSpPr/>
          <p:nvPr/>
        </p:nvGrpSpPr>
        <p:grpSpPr>
          <a:xfrm>
            <a:off x="125690" y="-73025"/>
            <a:ext cx="6633886" cy="6003925"/>
            <a:chOff x="1251895" y="470736"/>
            <a:chExt cx="4422035" cy="4002114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F6FA5434-922D-42EC-99E2-0E2EAEBFCAB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11626171"/>
                </p:ext>
              </p:extLst>
            </p:nvPr>
          </p:nvGraphicFramePr>
          <p:xfrm>
            <a:off x="1381869" y="490841"/>
            <a:ext cx="2121692" cy="201058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2" name="Prism 7" r:id="rId3" imgW="3485033" imgH="3302252" progId="Prism7.Document">
                    <p:embed/>
                  </p:oleObj>
                </mc:Choice>
                <mc:Fallback>
                  <p:oleObj name="Prism 7" r:id="rId3" imgW="3485033" imgH="3302252" progId="Prism7.Document">
                    <p:embed/>
                    <p:pic>
                      <p:nvPicPr>
                        <p:cNvPr id="61" name="Object 4">
                          <a:extLst>
                            <a:ext uri="{FF2B5EF4-FFF2-40B4-BE49-F238E27FC236}">
                              <a16:creationId xmlns:a16="http://schemas.microsoft.com/office/drawing/2014/main" id="{47B17322-4869-41D7-9A5B-890F5E51F7B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381869" y="490841"/>
                          <a:ext cx="2121692" cy="201058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11">
              <a:extLst>
                <a:ext uri="{FF2B5EF4-FFF2-40B4-BE49-F238E27FC236}">
                  <a16:creationId xmlns:a16="http://schemas.microsoft.com/office/drawing/2014/main" id="{46278C0B-C533-4379-B7BC-AFA9138F489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98632940"/>
                </p:ext>
              </p:extLst>
            </p:nvPr>
          </p:nvGraphicFramePr>
          <p:xfrm>
            <a:off x="3544830" y="470736"/>
            <a:ext cx="2121692" cy="203174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3" name="Prism 7" r:id="rId5" imgW="3485033" imgH="3338988" progId="Prism7.Document">
                    <p:embed/>
                  </p:oleObj>
                </mc:Choice>
                <mc:Fallback>
                  <p:oleObj name="Prism 7" r:id="rId5" imgW="3485033" imgH="3338988" progId="Prism7.Document">
                    <p:embed/>
                    <p:pic>
                      <p:nvPicPr>
                        <p:cNvPr id="62" name="Object 11">
                          <a:extLst>
                            <a:ext uri="{FF2B5EF4-FFF2-40B4-BE49-F238E27FC236}">
                              <a16:creationId xmlns:a16="http://schemas.microsoft.com/office/drawing/2014/main" id="{2C74156D-A817-4FCC-9923-893FA389482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544830" y="470736"/>
                          <a:ext cx="2121692" cy="203174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3">
              <a:extLst>
                <a:ext uri="{FF2B5EF4-FFF2-40B4-BE49-F238E27FC236}">
                  <a16:creationId xmlns:a16="http://schemas.microsoft.com/office/drawing/2014/main" id="{15672C4F-5664-473A-A08D-336F63544D1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81268197"/>
                </p:ext>
              </p:extLst>
            </p:nvPr>
          </p:nvGraphicFramePr>
          <p:xfrm>
            <a:off x="1441128" y="2452746"/>
            <a:ext cx="2047618" cy="20084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4" name="Prism 9" r:id="rId7" imgW="3366189" imgH="3302252" progId="Prism9.Document">
                    <p:embed/>
                  </p:oleObj>
                </mc:Choice>
                <mc:Fallback>
                  <p:oleObj name="Prism 9" r:id="rId7" imgW="3366189" imgH="3302252" progId="Prism9.Document">
                    <p:embed/>
                    <p:pic>
                      <p:nvPicPr>
                        <p:cNvPr id="63" name="Object 3">
                          <a:extLst>
                            <a:ext uri="{FF2B5EF4-FFF2-40B4-BE49-F238E27FC236}">
                              <a16:creationId xmlns:a16="http://schemas.microsoft.com/office/drawing/2014/main" id="{CE2550FC-A045-4DAC-8B5F-11FFF2E52BB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441128" y="2452746"/>
                          <a:ext cx="2047618" cy="200846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5">
              <a:extLst>
                <a:ext uri="{FF2B5EF4-FFF2-40B4-BE49-F238E27FC236}">
                  <a16:creationId xmlns:a16="http://schemas.microsoft.com/office/drawing/2014/main" id="{F1593ED2-C40C-467C-A618-4DCA06C5A43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98699858"/>
                </p:ext>
              </p:extLst>
            </p:nvPr>
          </p:nvGraphicFramePr>
          <p:xfrm>
            <a:off x="3519434" y="2442164"/>
            <a:ext cx="2154496" cy="20306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5" name="Prism 9" r:id="rId9" imgW="3540134" imgH="3338988" progId="Prism9.Document">
                    <p:embed/>
                  </p:oleObj>
                </mc:Choice>
                <mc:Fallback>
                  <p:oleObj name="Prism 9" r:id="rId9" imgW="3540134" imgH="3338988" progId="Prism9.Document">
                    <p:embed/>
                    <p:pic>
                      <p:nvPicPr>
                        <p:cNvPr id="64" name="Object 5">
                          <a:extLst>
                            <a:ext uri="{FF2B5EF4-FFF2-40B4-BE49-F238E27FC236}">
                              <a16:creationId xmlns:a16="http://schemas.microsoft.com/office/drawing/2014/main" id="{3C3277F0-582C-4D54-B962-5C32CF06BD0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519434" y="2442164"/>
                          <a:ext cx="2154496" cy="203068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57869A46-681C-4CC1-AD18-814431CEE0A0}"/>
                </a:ext>
              </a:extLst>
            </p:cNvPr>
            <p:cNvSpPr txBox="1"/>
            <p:nvPr/>
          </p:nvSpPr>
          <p:spPr>
            <a:xfrm>
              <a:off x="1251895" y="478778"/>
              <a:ext cx="271622" cy="3282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830D270A-22AF-4DA2-974A-25D720ABA45E}"/>
                </a:ext>
              </a:extLst>
            </p:cNvPr>
            <p:cNvSpPr txBox="1"/>
            <p:nvPr/>
          </p:nvSpPr>
          <p:spPr>
            <a:xfrm>
              <a:off x="3390257" y="478778"/>
              <a:ext cx="271622" cy="3282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F12EC068-8394-48C5-ACFF-E07AFC95FF37}"/>
                </a:ext>
              </a:extLst>
            </p:cNvPr>
            <p:cNvSpPr txBox="1"/>
            <p:nvPr/>
          </p:nvSpPr>
          <p:spPr>
            <a:xfrm>
              <a:off x="1251895" y="2498078"/>
              <a:ext cx="283375" cy="3282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6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D12CBDAE-692B-407A-9A72-740B9E5FED0A}"/>
                </a:ext>
              </a:extLst>
            </p:cNvPr>
            <p:cNvSpPr txBox="1"/>
            <p:nvPr/>
          </p:nvSpPr>
          <p:spPr>
            <a:xfrm>
              <a:off x="3390257" y="2498078"/>
              <a:ext cx="283375" cy="3282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6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22D9830D-86C6-4AB5-A448-0CCB00E0729F}"/>
              </a:ext>
            </a:extLst>
          </p:cNvPr>
          <p:cNvSpPr txBox="1"/>
          <p:nvPr/>
        </p:nvSpPr>
        <p:spPr>
          <a:xfrm>
            <a:off x="6250141" y="9608515"/>
            <a:ext cx="66717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13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2467395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A730793-8EB4-4EA3-BB2D-0D3D1C08AEC1}"/>
              </a:ext>
            </a:extLst>
          </p:cNvPr>
          <p:cNvSpPr txBox="1"/>
          <p:nvPr/>
        </p:nvSpPr>
        <p:spPr>
          <a:xfrm>
            <a:off x="561552" y="495415"/>
            <a:ext cx="8290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WT BL6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465069D-0466-44DF-893F-6DDF4C15E810}"/>
              </a:ext>
            </a:extLst>
          </p:cNvPr>
          <p:cNvSpPr txBox="1"/>
          <p:nvPr/>
        </p:nvSpPr>
        <p:spPr>
          <a:xfrm>
            <a:off x="1533884" y="495415"/>
            <a:ext cx="9283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WT BL10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F621F8DF-AC41-49DB-A250-66481326AAEA}"/>
              </a:ext>
            </a:extLst>
          </p:cNvPr>
          <p:cNvSpPr txBox="1"/>
          <p:nvPr/>
        </p:nvSpPr>
        <p:spPr>
          <a:xfrm>
            <a:off x="2521939" y="495415"/>
            <a:ext cx="1117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WT BL6x10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70886CE2-8C26-4D02-A78C-5D28F801759B}"/>
              </a:ext>
            </a:extLst>
          </p:cNvPr>
          <p:cNvSpPr txBox="1"/>
          <p:nvPr/>
        </p:nvSpPr>
        <p:spPr>
          <a:xfrm>
            <a:off x="3830809" y="495415"/>
            <a:ext cx="652006" cy="2923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Lcn2</a:t>
            </a:r>
            <a:r>
              <a:rPr lang="it-IT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0255333D-1C5F-4A3C-A39C-8D65025E3621}"/>
              </a:ext>
            </a:extLst>
          </p:cNvPr>
          <p:cNvSpPr txBox="1"/>
          <p:nvPr/>
        </p:nvSpPr>
        <p:spPr>
          <a:xfrm>
            <a:off x="4747274" y="495415"/>
            <a:ext cx="554556" cy="2923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DX</a:t>
            </a:r>
            <a:endParaRPr lang="it-IT" sz="14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72CA8AA2-836B-419A-A8CA-897EB8B634B5}"/>
              </a:ext>
            </a:extLst>
          </p:cNvPr>
          <p:cNvSpPr txBox="1"/>
          <p:nvPr/>
        </p:nvSpPr>
        <p:spPr>
          <a:xfrm>
            <a:off x="5391490" y="495415"/>
            <a:ext cx="1116420" cy="2923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DXxLcn2</a:t>
            </a:r>
            <a:r>
              <a:rPr lang="it-IT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40430C20-B122-4A69-9B23-8E7D7D872DC1}"/>
              </a:ext>
            </a:extLst>
          </p:cNvPr>
          <p:cNvSpPr txBox="1"/>
          <p:nvPr/>
        </p:nvSpPr>
        <p:spPr>
          <a:xfrm rot="16200000">
            <a:off x="-365113" y="1507593"/>
            <a:ext cx="1138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3-month-old</a:t>
            </a:r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0DC16C1F-6880-499E-B114-A4D6F7D24BB4}"/>
              </a:ext>
            </a:extLst>
          </p:cNvPr>
          <p:cNvGrpSpPr/>
          <p:nvPr/>
        </p:nvGrpSpPr>
        <p:grpSpPr>
          <a:xfrm>
            <a:off x="353515" y="733224"/>
            <a:ext cx="6271074" cy="1897013"/>
            <a:chOff x="377899" y="2657274"/>
            <a:chExt cx="6271074" cy="1897013"/>
          </a:xfrm>
        </p:grpSpPr>
        <p:sp>
          <p:nvSpPr>
            <p:cNvPr id="48" name="Rettangolo 47">
              <a:extLst>
                <a:ext uri="{FF2B5EF4-FFF2-40B4-BE49-F238E27FC236}">
                  <a16:creationId xmlns:a16="http://schemas.microsoft.com/office/drawing/2014/main" id="{90C621E2-0C5E-4ACC-B441-B9A1AF51E5B3}"/>
                </a:ext>
              </a:extLst>
            </p:cNvPr>
            <p:cNvSpPr/>
            <p:nvPr/>
          </p:nvSpPr>
          <p:spPr>
            <a:xfrm>
              <a:off x="397915" y="2701928"/>
              <a:ext cx="6251058" cy="185235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36" name="Immagine 35">
              <a:extLst>
                <a:ext uri="{FF2B5EF4-FFF2-40B4-BE49-F238E27FC236}">
                  <a16:creationId xmlns:a16="http://schemas.microsoft.com/office/drawing/2014/main" id="{7939CED1-30E9-418E-ACC0-F7D27B46D5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19238" y="2732189"/>
              <a:ext cx="1003364" cy="1775218"/>
            </a:xfrm>
            <a:prstGeom prst="rect">
              <a:avLst/>
            </a:prstGeom>
          </p:spPr>
        </p:pic>
        <p:pic>
          <p:nvPicPr>
            <p:cNvPr id="95" name="Immagine 94">
              <a:extLst>
                <a:ext uri="{FF2B5EF4-FFF2-40B4-BE49-F238E27FC236}">
                  <a16:creationId xmlns:a16="http://schemas.microsoft.com/office/drawing/2014/main" id="{D9E8781B-7BCC-4756-92DC-62F2C77494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537529" y="2752725"/>
              <a:ext cx="969146" cy="1712595"/>
            </a:xfrm>
            <a:prstGeom prst="rect">
              <a:avLst/>
            </a:prstGeom>
          </p:spPr>
        </p:pic>
        <p:pic>
          <p:nvPicPr>
            <p:cNvPr id="103" name="Immagine 102">
              <a:extLst>
                <a:ext uri="{FF2B5EF4-FFF2-40B4-BE49-F238E27FC236}">
                  <a16:creationId xmlns:a16="http://schemas.microsoft.com/office/drawing/2014/main" id="{B899343D-3365-4ABC-9218-3834FC7C15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5817" b="100000" l="8633" r="89568">
                          <a14:foregroundMark x1="91007" y1="16555" x2="88849" y2="19463"/>
                          <a14:foregroundMark x1="81295" y1="8501" x2="34892" y2="6040"/>
                          <a14:foregroundMark x1="34892" y1="6040" x2="12590" y2="9620"/>
                          <a14:foregroundMark x1="29137" y1="10067" x2="27338" y2="6935"/>
                          <a14:foregroundMark x1="42806" y1="13647" x2="39928" y2="15660"/>
                          <a14:foregroundMark x1="65827" y1="16779" x2="56115" y2="11633"/>
                          <a14:foregroundMark x1="67266" y1="23714" x2="25899" y2="38255"/>
                          <a14:foregroundMark x1="25899" y1="38255" x2="15827" y2="97539"/>
                          <a14:foregroundMark x1="15827" y1="97539" x2="21583" y2="99776"/>
                        </a14:backgroundRemoval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340331" flipH="1">
              <a:off x="2498191" y="2657274"/>
              <a:ext cx="1024543" cy="1661315"/>
            </a:xfrm>
            <a:prstGeom prst="rect">
              <a:avLst/>
            </a:prstGeom>
          </p:spPr>
        </p:pic>
        <p:pic>
          <p:nvPicPr>
            <p:cNvPr id="105" name="Immagine 104">
              <a:extLst>
                <a:ext uri="{FF2B5EF4-FFF2-40B4-BE49-F238E27FC236}">
                  <a16:creationId xmlns:a16="http://schemas.microsoft.com/office/drawing/2014/main" id="{CB4CA9EF-967C-4B69-A566-322B4BAD61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ackgroundRemoval t="2756" b="89764" l="9278" r="89003">
                          <a14:foregroundMark x1="6186" y1="15748" x2="50859" y2="5906"/>
                          <a14:foregroundMark x1="50859" y1="5906" x2="88660" y2="7874"/>
                          <a14:foregroundMark x1="88660" y1="10039" x2="89003" y2="10039"/>
                          <a14:foregroundMark x1="75258" y1="6693" x2="28866" y2="2756"/>
                          <a14:foregroundMark x1="28866" y1="2756" x2="11340" y2="9252"/>
                          <a14:foregroundMark x1="63918" y1="58858" x2="63918" y2="79921"/>
                        </a14:backgroundRemoval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7899" y="2707005"/>
              <a:ext cx="1040366" cy="1819567"/>
            </a:xfrm>
            <a:prstGeom prst="rect">
              <a:avLst/>
            </a:prstGeom>
          </p:spPr>
        </p:pic>
        <p:pic>
          <p:nvPicPr>
            <p:cNvPr id="108" name="Immagine 107" descr="Immagine che contiene scuro, inpiedi, uccello, stanza&#10;&#10;Descrizione generata automaticamente">
              <a:extLst>
                <a:ext uri="{FF2B5EF4-FFF2-40B4-BE49-F238E27FC236}">
                  <a16:creationId xmlns:a16="http://schemas.microsoft.com/office/drawing/2014/main" id="{70C4537A-710D-43C6-A9DA-55649CFC90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ackgroundRemoval t="0" b="100000" l="9907" r="94427">
                          <a14:foregroundMark x1="94427" y1="17532" x2="91331" y2="17532"/>
                          <a14:foregroundMark x1="91331" y1="17532" x2="74613" y2="6277"/>
                          <a14:foregroundMark x1="36533" y1="0" x2="50774" y2="1515"/>
                          <a14:foregroundMark x1="54489" y1="17100" x2="33746" y2="62554"/>
                          <a14:foregroundMark x1="35604" y1="59307" x2="27864" y2="85931"/>
                          <a14:foregroundMark x1="59752" y1="24026" x2="71517" y2="17316"/>
                        </a14:backgroundRemoval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388129" flipH="1">
              <a:off x="1354328" y="2695573"/>
              <a:ext cx="1189847" cy="1713894"/>
            </a:xfrm>
            <a:prstGeom prst="rect">
              <a:avLst/>
            </a:prstGeom>
          </p:spPr>
        </p:pic>
        <p:pic>
          <p:nvPicPr>
            <p:cNvPr id="100" name="Immagine 99">
              <a:extLst>
                <a:ext uri="{FF2B5EF4-FFF2-40B4-BE49-F238E27FC236}">
                  <a16:creationId xmlns:a16="http://schemas.microsoft.com/office/drawing/2014/main" id="{7F6DD677-D467-40F2-9462-33489BB0D4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ackgroundRemoval t="1068" b="100000" l="9609" r="90391">
                          <a14:foregroundMark x1="86833" y1="21581" x2="53381" y2="1496"/>
                          <a14:foregroundMark x1="53381" y1="1496" x2="17794" y2="21368"/>
                          <a14:foregroundMark x1="17438" y1="21368" x2="8897" y2="99786"/>
                          <a14:foregroundMark x1="15302" y1="49786" x2="8897" y2="99786"/>
                          <a14:foregroundMark x1="15658" y1="49786" x2="59786" y2="35256"/>
                          <a14:foregroundMark x1="59786" y1="35256" x2="23843" y2="12607"/>
                          <a14:foregroundMark x1="23843" y1="12607" x2="72242" y2="18590"/>
                          <a14:foregroundMark x1="72242" y1="18590" x2="29181" y2="6197"/>
                          <a14:foregroundMark x1="29181" y1="6197" x2="91459" y2="10470"/>
                          <a14:foregroundMark x1="50890" y1="41667" x2="28114" y2="68803"/>
                          <a14:foregroundMark x1="28114" y1="68803" x2="20641" y2="98291"/>
                          <a14:foregroundMark x1="20641" y1="98291" x2="42349" y2="40598"/>
                          <a14:foregroundMark x1="42349" y1="40598" x2="21708" y2="67949"/>
                          <a14:foregroundMark x1="21708" y1="67949" x2="26335" y2="43803"/>
                          <a14:foregroundMark x1="25267" y1="99573" x2="21708" y2="99786"/>
                          <a14:foregroundMark x1="44128" y1="1709" x2="51601" y2="1282"/>
                          <a14:foregroundMark x1="52313" y1="3419" x2="75089" y2="2350"/>
                        </a14:backgroundRemoval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710216" flipH="1">
              <a:off x="3533188" y="2732888"/>
              <a:ext cx="1009566" cy="1685112"/>
            </a:xfrm>
            <a:prstGeom prst="rect">
              <a:avLst/>
            </a:prstGeom>
          </p:spPr>
        </p:pic>
        <p:sp>
          <p:nvSpPr>
            <p:cNvPr id="58" name="Rettangolo 57">
              <a:extLst>
                <a:ext uri="{FF2B5EF4-FFF2-40B4-BE49-F238E27FC236}">
                  <a16:creationId xmlns:a16="http://schemas.microsoft.com/office/drawing/2014/main" id="{27BD7868-EC4A-446C-A455-81F3364E127D}"/>
                </a:ext>
              </a:extLst>
            </p:cNvPr>
            <p:cNvSpPr/>
            <p:nvPr/>
          </p:nvSpPr>
          <p:spPr>
            <a:xfrm>
              <a:off x="426322" y="4290060"/>
              <a:ext cx="6180218" cy="25219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5" name="Gruppo 4">
            <a:extLst>
              <a:ext uri="{FF2B5EF4-FFF2-40B4-BE49-F238E27FC236}">
                <a16:creationId xmlns:a16="http://schemas.microsoft.com/office/drawing/2014/main" id="{F2052CC2-9F77-4943-8DB8-311B5C850B0E}"/>
              </a:ext>
            </a:extLst>
          </p:cNvPr>
          <p:cNvGrpSpPr/>
          <p:nvPr/>
        </p:nvGrpSpPr>
        <p:grpSpPr>
          <a:xfrm>
            <a:off x="69597" y="2978099"/>
            <a:ext cx="6557136" cy="1919088"/>
            <a:chOff x="81789" y="5016449"/>
            <a:chExt cx="6557136" cy="1919088"/>
          </a:xfrm>
        </p:grpSpPr>
        <p:sp>
          <p:nvSpPr>
            <p:cNvPr id="53" name="Rettangolo 52">
              <a:extLst>
                <a:ext uri="{FF2B5EF4-FFF2-40B4-BE49-F238E27FC236}">
                  <a16:creationId xmlns:a16="http://schemas.microsoft.com/office/drawing/2014/main" id="{89942349-6853-4298-9FF8-0831A7E00F16}"/>
                </a:ext>
              </a:extLst>
            </p:cNvPr>
            <p:cNvSpPr/>
            <p:nvPr/>
          </p:nvSpPr>
          <p:spPr>
            <a:xfrm>
              <a:off x="387867" y="5083178"/>
              <a:ext cx="6251058" cy="185235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51" name="Immagine 50">
              <a:extLst>
                <a:ext uri="{FF2B5EF4-FFF2-40B4-BE49-F238E27FC236}">
                  <a16:creationId xmlns:a16="http://schemas.microsoft.com/office/drawing/2014/main" id="{B4FF39A4-BCBD-468B-89C0-0141E0A4A2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3306" y="5097463"/>
              <a:ext cx="991326" cy="1804987"/>
            </a:xfrm>
            <a:prstGeom prst="rect">
              <a:avLst/>
            </a:prstGeom>
          </p:spPr>
        </p:pic>
        <p:pic>
          <p:nvPicPr>
            <p:cNvPr id="30" name="Immagine 29">
              <a:extLst>
                <a:ext uri="{FF2B5EF4-FFF2-40B4-BE49-F238E27FC236}">
                  <a16:creationId xmlns:a16="http://schemas.microsoft.com/office/drawing/2014/main" id="{6524B8FD-62A8-4FC2-8AF0-7B4E8FA75C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5556242" y="5086347"/>
              <a:ext cx="1019393" cy="1784354"/>
            </a:xfrm>
            <a:prstGeom prst="rect">
              <a:avLst/>
            </a:prstGeom>
          </p:spPr>
        </p:pic>
        <p:pic>
          <p:nvPicPr>
            <p:cNvPr id="15" name="Immagine 14">
              <a:extLst>
                <a:ext uri="{FF2B5EF4-FFF2-40B4-BE49-F238E27FC236}">
                  <a16:creationId xmlns:a16="http://schemas.microsoft.com/office/drawing/2014/main" id="{FC0B1B99-439C-43CE-BB5F-AAFF7A1CFE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3628101" y="5105403"/>
              <a:ext cx="1060293" cy="1758947"/>
            </a:xfrm>
            <a:prstGeom prst="rect">
              <a:avLst/>
            </a:prstGeom>
          </p:spPr>
        </p:pic>
        <p:pic>
          <p:nvPicPr>
            <p:cNvPr id="46" name="Immagine 45">
              <a:extLst>
                <a:ext uri="{FF2B5EF4-FFF2-40B4-BE49-F238E27FC236}">
                  <a16:creationId xmlns:a16="http://schemas.microsoft.com/office/drawing/2014/main" id="{3F736B09-30FD-4448-ACF9-F2AB68FAA4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ackgroundRemoval t="2998" b="100000" l="8042" r="88462">
                          <a14:foregroundMark x1="17133" y1="20343" x2="56993" y2="6638"/>
                          <a14:foregroundMark x1="56993" y1="6638" x2="77972" y2="13704"/>
                          <a14:foregroundMark x1="6993" y1="16702" x2="47902" y2="5567"/>
                          <a14:foregroundMark x1="47902" y1="5567" x2="75874" y2="5782"/>
                          <a14:foregroundMark x1="25874" y1="20557" x2="57343" y2="42398"/>
                          <a14:foregroundMark x1="57343" y1="42398" x2="79021" y2="42612"/>
                          <a14:foregroundMark x1="74825" y1="60171" x2="66084" y2="20771"/>
                          <a14:foregroundMark x1="41259" y1="20343" x2="62587" y2="38116"/>
                          <a14:foregroundMark x1="56993" y1="26124" x2="84266" y2="17987"/>
                          <a14:foregroundMark x1="71678" y1="32334" x2="75524" y2="25910"/>
                          <a14:foregroundMark x1="80070" y1="25482" x2="80070" y2="25482"/>
                          <a14:foregroundMark x1="66783" y1="30835" x2="52448" y2="31049"/>
                          <a14:foregroundMark x1="36713" y1="30193" x2="62587" y2="54176"/>
                          <a14:foregroundMark x1="62587" y1="54176" x2="68182" y2="87580"/>
                          <a14:foregroundMark x1="79371" y1="61884" x2="69580" y2="99786"/>
                          <a14:foregroundMark x1="89161" y1="38972" x2="86364" y2="58887"/>
                          <a14:foregroundMark x1="87762" y1="69807" x2="83566" y2="13919"/>
                          <a14:foregroundMark x1="83566" y1="13919" x2="39860" y2="2998"/>
                          <a14:foregroundMark x1="39860" y1="2998" x2="34615" y2="4711"/>
                        </a14:backgroundRemoval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76699">
              <a:off x="4520849" y="5070100"/>
              <a:ext cx="1060293" cy="1732686"/>
            </a:xfrm>
            <a:prstGeom prst="rect">
              <a:avLst/>
            </a:prstGeom>
          </p:spPr>
        </p:pic>
        <p:pic>
          <p:nvPicPr>
            <p:cNvPr id="49" name="Immagine 48">
              <a:extLst>
                <a:ext uri="{FF2B5EF4-FFF2-40B4-BE49-F238E27FC236}">
                  <a16:creationId xmlns:a16="http://schemas.microsoft.com/office/drawing/2014/main" id="{509118C4-3557-4D5D-B286-F47DA3D62D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ackgroundRemoval t="8419" b="100000" l="9790" r="89161">
                          <a14:foregroundMark x1="92308" y1="19713" x2="48951" y2="9240"/>
                          <a14:foregroundMark x1="48951" y1="9240" x2="22378" y2="8830"/>
                          <a14:foregroundMark x1="43706" y1="26899" x2="19930" y2="61191"/>
                          <a14:foregroundMark x1="32517" y1="28542" x2="21329" y2="92197"/>
                          <a14:foregroundMark x1="32517" y1="40041" x2="51399" y2="28131"/>
                          <a14:foregroundMark x1="50350" y1="28131" x2="50350" y2="28131"/>
                          <a14:foregroundMark x1="64336" y1="32649" x2="21678" y2="21971"/>
                          <a14:foregroundMark x1="21678" y1="21971" x2="17832" y2="32444"/>
                          <a14:foregroundMark x1="49650" y1="17864" x2="48252" y2="25873"/>
                        </a14:backgroundRemoval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305494" flipH="1">
              <a:off x="2535139" y="5016449"/>
              <a:ext cx="1060293" cy="1807070"/>
            </a:xfrm>
            <a:prstGeom prst="rect">
              <a:avLst/>
            </a:prstGeom>
          </p:spPr>
        </p:pic>
        <p:pic>
          <p:nvPicPr>
            <p:cNvPr id="54" name="Immagine 53">
              <a:extLst>
                <a:ext uri="{FF2B5EF4-FFF2-40B4-BE49-F238E27FC236}">
                  <a16:creationId xmlns:a16="http://schemas.microsoft.com/office/drawing/2014/main" id="{4D3BA507-5AD1-44B6-810C-A08756FA73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68277" y="5139690"/>
              <a:ext cx="991327" cy="1711960"/>
            </a:xfrm>
            <a:prstGeom prst="rect">
              <a:avLst/>
            </a:prstGeom>
          </p:spPr>
        </p:pic>
        <p:sp>
          <p:nvSpPr>
            <p:cNvPr id="92" name="CasellaDiTesto 91">
              <a:extLst>
                <a:ext uri="{FF2B5EF4-FFF2-40B4-BE49-F238E27FC236}">
                  <a16:creationId xmlns:a16="http://schemas.microsoft.com/office/drawing/2014/main" id="{57AE6F88-EA37-4C93-AFCF-5DE3337A8909}"/>
                </a:ext>
              </a:extLst>
            </p:cNvPr>
            <p:cNvSpPr txBox="1"/>
            <p:nvPr/>
          </p:nvSpPr>
          <p:spPr>
            <a:xfrm rot="16200000">
              <a:off x="-333549" y="5842766"/>
              <a:ext cx="11384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>
                  <a:latin typeface="Arial" panose="020B0604020202020204" pitchFamily="34" charset="0"/>
                  <a:cs typeface="Arial" panose="020B0604020202020204" pitchFamily="34" charset="0"/>
                </a:rPr>
                <a:t>6-month-old</a:t>
              </a:r>
            </a:p>
          </p:txBody>
        </p:sp>
        <p:sp>
          <p:nvSpPr>
            <p:cNvPr id="59" name="Rettangolo 58">
              <a:extLst>
                <a:ext uri="{FF2B5EF4-FFF2-40B4-BE49-F238E27FC236}">
                  <a16:creationId xmlns:a16="http://schemas.microsoft.com/office/drawing/2014/main" id="{26D85DD6-33D6-4AB7-8E08-4B2135C5AEDB}"/>
                </a:ext>
              </a:extLst>
            </p:cNvPr>
            <p:cNvSpPr/>
            <p:nvPr/>
          </p:nvSpPr>
          <p:spPr>
            <a:xfrm>
              <a:off x="432672" y="6664960"/>
              <a:ext cx="6180218" cy="25219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6" name="Gruppo 5">
            <a:extLst>
              <a:ext uri="{FF2B5EF4-FFF2-40B4-BE49-F238E27FC236}">
                <a16:creationId xmlns:a16="http://schemas.microsoft.com/office/drawing/2014/main" id="{A33536A9-70C6-4A44-9E8E-0C123314B58A}"/>
              </a:ext>
            </a:extLst>
          </p:cNvPr>
          <p:cNvGrpSpPr/>
          <p:nvPr/>
        </p:nvGrpSpPr>
        <p:grpSpPr>
          <a:xfrm>
            <a:off x="54977" y="5301912"/>
            <a:ext cx="6570994" cy="1866035"/>
            <a:chOff x="201281" y="7622202"/>
            <a:chExt cx="6570994" cy="1866035"/>
          </a:xfrm>
        </p:grpSpPr>
        <p:sp>
          <p:nvSpPr>
            <p:cNvPr id="57" name="Rettangolo 56">
              <a:extLst>
                <a:ext uri="{FF2B5EF4-FFF2-40B4-BE49-F238E27FC236}">
                  <a16:creationId xmlns:a16="http://schemas.microsoft.com/office/drawing/2014/main" id="{01B4C8BD-A278-4359-8B6B-402287722A72}"/>
                </a:ext>
              </a:extLst>
            </p:cNvPr>
            <p:cNvSpPr/>
            <p:nvPr/>
          </p:nvSpPr>
          <p:spPr>
            <a:xfrm>
              <a:off x="521217" y="7635878"/>
              <a:ext cx="6251058" cy="185235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74" name="Immagine 73">
              <a:extLst>
                <a:ext uri="{FF2B5EF4-FFF2-40B4-BE49-F238E27FC236}">
                  <a16:creationId xmlns:a16="http://schemas.microsoft.com/office/drawing/2014/main" id="{FA81983F-2E69-4D1B-8A60-7EE68DBB96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89417" y="7645399"/>
              <a:ext cx="1006586" cy="1801895"/>
            </a:xfrm>
            <a:prstGeom prst="rect">
              <a:avLst/>
            </a:prstGeom>
          </p:spPr>
        </p:pic>
        <p:pic>
          <p:nvPicPr>
            <p:cNvPr id="68" name="Immagine 67">
              <a:extLst>
                <a:ext uri="{FF2B5EF4-FFF2-40B4-BE49-F238E27FC236}">
                  <a16:creationId xmlns:a16="http://schemas.microsoft.com/office/drawing/2014/main" id="{FD9CC33C-7919-4388-9B3C-C2A240C3F7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ackgroundRemoval t="1245" b="97510" l="9859" r="89789">
                          <a14:foregroundMark x1="12324" y1="18257" x2="49648" y2="1452"/>
                          <a14:foregroundMark x1="49648" y1="1452" x2="46479" y2="29461"/>
                          <a14:foregroundMark x1="46479" y1="29461" x2="72183" y2="51660"/>
                          <a14:foregroundMark x1="72183" y1="51660" x2="76408" y2="87759"/>
                          <a14:foregroundMark x1="79930" y1="60788" x2="78169" y2="33610"/>
                          <a14:foregroundMark x1="78169" y1="33610" x2="55634" y2="10373"/>
                          <a14:foregroundMark x1="55634" y1="10373" x2="26408" y2="20954"/>
                          <a14:foregroundMark x1="41549" y1="7469" x2="20070" y2="16183"/>
                          <a14:foregroundMark x1="9859" y1="8506" x2="37324" y2="21162"/>
                          <a14:foregroundMark x1="35563" y1="12033" x2="41197" y2="11618"/>
                          <a14:foregroundMark x1="77465" y1="13693" x2="79225" y2="22199"/>
                          <a14:foregroundMark x1="83099" y1="12033" x2="39085" y2="3942"/>
                          <a14:foregroundMark x1="39085" y1="3942" x2="13732" y2="17012"/>
                          <a14:foregroundMark x1="85915" y1="59129" x2="90493" y2="50415"/>
                          <a14:foregroundMark x1="85211" y1="97718" x2="60211" y2="93983"/>
                        </a14:backgroundRemoval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516458">
              <a:off x="4647087" y="7644888"/>
              <a:ext cx="1051559" cy="1784350"/>
            </a:xfrm>
            <a:prstGeom prst="rect">
              <a:avLst/>
            </a:prstGeom>
          </p:spPr>
        </p:pic>
        <p:pic>
          <p:nvPicPr>
            <p:cNvPr id="56" name="Immagine 55">
              <a:extLst>
                <a:ext uri="{FF2B5EF4-FFF2-40B4-BE49-F238E27FC236}">
                  <a16:creationId xmlns:a16="http://schemas.microsoft.com/office/drawing/2014/main" id="{79BD17B0-6C8E-4198-B223-4A17435745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96899" y="7645401"/>
              <a:ext cx="946151" cy="1778000"/>
            </a:xfrm>
            <a:prstGeom prst="rect">
              <a:avLst/>
            </a:prstGeom>
          </p:spPr>
        </p:pic>
        <p:pic>
          <p:nvPicPr>
            <p:cNvPr id="62" name="Immagine 61">
              <a:extLst>
                <a:ext uri="{FF2B5EF4-FFF2-40B4-BE49-F238E27FC236}">
                  <a16:creationId xmlns:a16="http://schemas.microsoft.com/office/drawing/2014/main" id="{35D67B00-E752-4129-B926-28EDA26B95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 cstate="print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45848" y="7648026"/>
              <a:ext cx="1003039" cy="1794424"/>
            </a:xfrm>
            <a:prstGeom prst="rect">
              <a:avLst/>
            </a:prstGeom>
          </p:spPr>
        </p:pic>
        <p:pic>
          <p:nvPicPr>
            <p:cNvPr id="85" name="Immagine 84">
              <a:extLst>
                <a:ext uri="{FF2B5EF4-FFF2-40B4-BE49-F238E27FC236}">
                  <a16:creationId xmlns:a16="http://schemas.microsoft.com/office/drawing/2014/main" id="{1A0C0B6A-5F63-46AE-B7A1-C5CF09D149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 cstate="print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ackgroundRemoval t="1452" b="100000" l="7473" r="90036">
                          <a14:foregroundMark x1="88968" y1="18050" x2="52669" y2="1867"/>
                          <a14:foregroundMark x1="52669" y1="1867" x2="23132" y2="21162"/>
                          <a14:foregroundMark x1="23132" y1="21162" x2="11744" y2="74066"/>
                          <a14:foregroundMark x1="11744" y1="74066" x2="16014" y2="99585"/>
                          <a14:foregroundMark x1="16014" y1="99585" x2="47331" y2="23237"/>
                          <a14:foregroundMark x1="47331" y1="23237" x2="37367" y2="20539"/>
                          <a14:foregroundMark x1="45196" y1="26763" x2="17794" y2="92946"/>
                          <a14:foregroundMark x1="43416" y1="16598" x2="49466" y2="9959"/>
                          <a14:foregroundMark x1="16726" y1="67220" x2="28114" y2="35892"/>
                          <a14:foregroundMark x1="9253" y1="65560" x2="7473" y2="59544"/>
                          <a14:foregroundMark x1="45196" y1="7884" x2="88968" y2="12241"/>
                          <a14:foregroundMark x1="88968" y1="12241" x2="40214" y2="60373"/>
                          <a14:foregroundMark x1="40214" y1="60373" x2="37367" y2="87759"/>
                          <a14:foregroundMark x1="37367" y1="87759" x2="13523" y2="65975"/>
                          <a14:foregroundMark x1="13523" y1="65975" x2="27758" y2="10788"/>
                          <a14:foregroundMark x1="27758" y1="10788" x2="39146" y2="4357"/>
                        </a14:backgroundRemoval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336667" flipH="1">
              <a:off x="3687280" y="7622202"/>
              <a:ext cx="1053441" cy="1785835"/>
            </a:xfrm>
            <a:prstGeom prst="rect">
              <a:avLst/>
            </a:prstGeom>
          </p:spPr>
        </p:pic>
        <p:pic>
          <p:nvPicPr>
            <p:cNvPr id="89" name="Immagine 88">
              <a:extLst>
                <a:ext uri="{FF2B5EF4-FFF2-40B4-BE49-F238E27FC236}">
                  <a16:creationId xmlns:a16="http://schemas.microsoft.com/office/drawing/2014/main" id="{85B666D9-C19A-4C5B-A526-CF650250BE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 cstate="print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ackgroundRemoval t="5579" b="100000" l="7309" r="91030">
                          <a14:foregroundMark x1="70100" y1="52361" x2="45847" y2="27468"/>
                          <a14:foregroundMark x1="45847" y1="27468" x2="50498" y2="34979"/>
                          <a14:foregroundMark x1="7641" y1="15236" x2="50831" y2="8369"/>
                          <a14:foregroundMark x1="50831" y1="8369" x2="65781" y2="94421"/>
                          <a14:foregroundMark x1="65781" y1="94421" x2="64120" y2="36695"/>
                          <a14:foregroundMark x1="64120" y1="36695" x2="77076" y2="46567"/>
                          <a14:foregroundMark x1="57807" y1="33906" x2="24917" y2="18240"/>
                          <a14:foregroundMark x1="24917" y1="18240" x2="42525" y2="28755"/>
                          <a14:foregroundMark x1="54485" y1="9442" x2="13621" y2="8155"/>
                          <a14:foregroundMark x1="13621" y1="8155" x2="8306" y2="16738"/>
                          <a14:foregroundMark x1="44850" y1="7725" x2="19601" y2="5794"/>
                          <a14:foregroundMark x1="36877" y1="31974" x2="63455" y2="56867"/>
                          <a14:foregroundMark x1="63455" y1="56867" x2="65781" y2="62876"/>
                          <a14:foregroundMark x1="74086" y1="14163" x2="78073" y2="7725"/>
                          <a14:foregroundMark x1="91030" y1="19313" x2="82060" y2="16094"/>
                        </a14:backgroundRemoval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53048" y="7637715"/>
              <a:ext cx="1116894" cy="1728536"/>
            </a:xfrm>
            <a:prstGeom prst="rect">
              <a:avLst/>
            </a:prstGeom>
          </p:spPr>
        </p:pic>
        <p:sp>
          <p:nvSpPr>
            <p:cNvPr id="93" name="CasellaDiTesto 92">
              <a:extLst>
                <a:ext uri="{FF2B5EF4-FFF2-40B4-BE49-F238E27FC236}">
                  <a16:creationId xmlns:a16="http://schemas.microsoft.com/office/drawing/2014/main" id="{11088CE3-DB9E-47DD-8B81-337365712B45}"/>
                </a:ext>
              </a:extLst>
            </p:cNvPr>
            <p:cNvSpPr txBox="1"/>
            <p:nvPr/>
          </p:nvSpPr>
          <p:spPr>
            <a:xfrm rot="16200000">
              <a:off x="-263750" y="8413123"/>
              <a:ext cx="12378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>
                  <a:latin typeface="Arial" panose="020B0604020202020204" pitchFamily="34" charset="0"/>
                  <a:cs typeface="Arial" panose="020B0604020202020204" pitchFamily="34" charset="0"/>
                </a:rPr>
                <a:t>12-month-old</a:t>
              </a:r>
            </a:p>
          </p:txBody>
        </p:sp>
        <p:sp>
          <p:nvSpPr>
            <p:cNvPr id="60" name="Rettangolo 59">
              <a:extLst>
                <a:ext uri="{FF2B5EF4-FFF2-40B4-BE49-F238E27FC236}">
                  <a16:creationId xmlns:a16="http://schemas.microsoft.com/office/drawing/2014/main" id="{2C0469C9-EB0A-42F0-ADAA-F007498D2780}"/>
                </a:ext>
              </a:extLst>
            </p:cNvPr>
            <p:cNvSpPr/>
            <p:nvPr/>
          </p:nvSpPr>
          <p:spPr>
            <a:xfrm>
              <a:off x="559672" y="9217660"/>
              <a:ext cx="6180218" cy="25219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9B55D102-AEB2-4641-AB8C-C098B2B30D4C}"/>
              </a:ext>
            </a:extLst>
          </p:cNvPr>
          <p:cNvSpPr txBox="1"/>
          <p:nvPr/>
        </p:nvSpPr>
        <p:spPr>
          <a:xfrm>
            <a:off x="6250141" y="9608515"/>
            <a:ext cx="66717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13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3027080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18183D99-A2B8-4464-B30C-18ECCACCBD1A}"/>
              </a:ext>
            </a:extLst>
          </p:cNvPr>
          <p:cNvSpPr txBox="1"/>
          <p:nvPr/>
        </p:nvSpPr>
        <p:spPr>
          <a:xfrm>
            <a:off x="0" y="0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49F5BB72-6677-491E-8D4C-D324D53E61A4}"/>
              </a:ext>
            </a:extLst>
          </p:cNvPr>
          <p:cNvSpPr txBox="1"/>
          <p:nvPr/>
        </p:nvSpPr>
        <p:spPr>
          <a:xfrm>
            <a:off x="0" y="4008628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560C8798-A8DD-419C-BEF5-C3D33B51F6C8}"/>
              </a:ext>
            </a:extLst>
          </p:cNvPr>
          <p:cNvSpPr txBox="1"/>
          <p:nvPr/>
        </p:nvSpPr>
        <p:spPr>
          <a:xfrm flipH="1">
            <a:off x="896149" y="4422469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WT BL6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8315B09F-B3C9-4B15-BEFB-A15F1793FA64}"/>
              </a:ext>
            </a:extLst>
          </p:cNvPr>
          <p:cNvSpPr txBox="1"/>
          <p:nvPr/>
        </p:nvSpPr>
        <p:spPr>
          <a:xfrm flipH="1">
            <a:off x="3006262" y="4422469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WT BL10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608391FE-0AAF-4DF4-81B4-D52A501BC6A6}"/>
              </a:ext>
            </a:extLst>
          </p:cNvPr>
          <p:cNvSpPr txBox="1"/>
          <p:nvPr/>
        </p:nvSpPr>
        <p:spPr>
          <a:xfrm flipH="1">
            <a:off x="4870314" y="4422469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WT BL6x10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20F2A14F-A741-4003-8D6E-D7180ABFF5EE}"/>
              </a:ext>
            </a:extLst>
          </p:cNvPr>
          <p:cNvSpPr txBox="1"/>
          <p:nvPr/>
        </p:nvSpPr>
        <p:spPr>
          <a:xfrm flipH="1">
            <a:off x="981493" y="6131407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Lcn2</a:t>
            </a:r>
            <a:r>
              <a:rPr lang="it-IT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D10F8738-A441-416B-B308-FB8B8CB2E8ED}"/>
              </a:ext>
            </a:extLst>
          </p:cNvPr>
          <p:cNvSpPr txBox="1"/>
          <p:nvPr/>
        </p:nvSpPr>
        <p:spPr>
          <a:xfrm flipH="1">
            <a:off x="3103798" y="6131407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DX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96741A63-387D-4CF8-96FE-C32080952443}"/>
              </a:ext>
            </a:extLst>
          </p:cNvPr>
          <p:cNvSpPr txBox="1"/>
          <p:nvPr/>
        </p:nvSpPr>
        <p:spPr>
          <a:xfrm flipH="1">
            <a:off x="4943466" y="6131407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DXxLcn2</a:t>
            </a:r>
            <a:r>
              <a:rPr lang="it-IT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8DFFBD45-4A8C-4317-908E-AB98053F29D3}"/>
              </a:ext>
            </a:extLst>
          </p:cNvPr>
          <p:cNvSpPr txBox="1"/>
          <p:nvPr/>
        </p:nvSpPr>
        <p:spPr>
          <a:xfrm>
            <a:off x="2456137" y="4127500"/>
            <a:ext cx="1945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Toluidine blue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Connettore diritto 52">
            <a:extLst>
              <a:ext uri="{FF2B5EF4-FFF2-40B4-BE49-F238E27FC236}">
                <a16:creationId xmlns:a16="http://schemas.microsoft.com/office/drawing/2014/main" id="{76E157AD-76BF-4E17-8BA9-B7BE4CB8825A}"/>
              </a:ext>
            </a:extLst>
          </p:cNvPr>
          <p:cNvCxnSpPr>
            <a:cxnSpLocks/>
          </p:cNvCxnSpPr>
          <p:nvPr/>
        </p:nvCxnSpPr>
        <p:spPr>
          <a:xfrm flipV="1">
            <a:off x="330661" y="4435277"/>
            <a:ext cx="6194839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5BC3D3AA-FF28-4DD9-BE59-17513613FC63}"/>
              </a:ext>
            </a:extLst>
          </p:cNvPr>
          <p:cNvSpPr txBox="1"/>
          <p:nvPr/>
        </p:nvSpPr>
        <p:spPr>
          <a:xfrm flipH="1">
            <a:off x="901544" y="448786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WT BL6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4EBE7D64-DC4D-478F-B6B5-387CA0046EC1}"/>
              </a:ext>
            </a:extLst>
          </p:cNvPr>
          <p:cNvSpPr txBox="1"/>
          <p:nvPr/>
        </p:nvSpPr>
        <p:spPr>
          <a:xfrm flipH="1">
            <a:off x="3011657" y="448786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WT BL10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B2B909ED-18DC-4F37-8188-1A55EFAD5FA1}"/>
              </a:ext>
            </a:extLst>
          </p:cNvPr>
          <p:cNvSpPr txBox="1"/>
          <p:nvPr/>
        </p:nvSpPr>
        <p:spPr>
          <a:xfrm flipH="1">
            <a:off x="4847769" y="448786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WT BL6x10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70D4FA04-107E-4EF5-899E-A01A1C0FCB17}"/>
              </a:ext>
            </a:extLst>
          </p:cNvPr>
          <p:cNvSpPr txBox="1"/>
          <p:nvPr/>
        </p:nvSpPr>
        <p:spPr>
          <a:xfrm flipH="1">
            <a:off x="999080" y="2125192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Lcn2</a:t>
            </a:r>
            <a:r>
              <a:rPr lang="it-IT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7904278D-6F78-4ABF-B838-2B1E21A04310}"/>
              </a:ext>
            </a:extLst>
          </p:cNvPr>
          <p:cNvSpPr txBox="1"/>
          <p:nvPr/>
        </p:nvSpPr>
        <p:spPr>
          <a:xfrm flipH="1">
            <a:off x="3097001" y="2125192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DX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46C2F537-2BAB-4A0A-A8CD-76646118A4EC}"/>
              </a:ext>
            </a:extLst>
          </p:cNvPr>
          <p:cNvSpPr txBox="1"/>
          <p:nvPr/>
        </p:nvSpPr>
        <p:spPr>
          <a:xfrm flipH="1">
            <a:off x="4945305" y="2125192"/>
            <a:ext cx="1582034" cy="286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DXxLcn2</a:t>
            </a:r>
            <a:r>
              <a:rPr lang="it-IT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32BA37B1-61CC-4F55-BA20-BCC89EF9BFA2}"/>
              </a:ext>
            </a:extLst>
          </p:cNvPr>
          <p:cNvSpPr txBox="1"/>
          <p:nvPr/>
        </p:nvSpPr>
        <p:spPr>
          <a:xfrm>
            <a:off x="2152650" y="152400"/>
            <a:ext cx="2542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TRAcP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histochemical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73774A25-CCEC-4B7B-BEF6-B7B3F0018F24}"/>
              </a:ext>
            </a:extLst>
          </p:cNvPr>
          <p:cNvSpPr txBox="1"/>
          <p:nvPr/>
        </p:nvSpPr>
        <p:spPr>
          <a:xfrm>
            <a:off x="6250141" y="9608515"/>
            <a:ext cx="66717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13" dirty="0"/>
              <a:t>Figure S3</a:t>
            </a:r>
          </a:p>
        </p:txBody>
      </p:sp>
      <p:cxnSp>
        <p:nvCxnSpPr>
          <p:cNvPr id="37" name="Connettore diritto 36">
            <a:extLst>
              <a:ext uri="{FF2B5EF4-FFF2-40B4-BE49-F238E27FC236}">
                <a16:creationId xmlns:a16="http://schemas.microsoft.com/office/drawing/2014/main" id="{179CFC35-9A40-4EBF-9E8B-654BC3F01CCD}"/>
              </a:ext>
            </a:extLst>
          </p:cNvPr>
          <p:cNvCxnSpPr>
            <a:cxnSpLocks/>
          </p:cNvCxnSpPr>
          <p:nvPr/>
        </p:nvCxnSpPr>
        <p:spPr>
          <a:xfrm flipV="1">
            <a:off x="330661" y="460177"/>
            <a:ext cx="6194839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Immagine 34">
            <a:extLst>
              <a:ext uri="{FF2B5EF4-FFF2-40B4-BE49-F238E27FC236}">
                <a16:creationId xmlns:a16="http://schemas.microsoft.com/office/drawing/2014/main" id="{35330BAF-9343-4C02-897D-F6C46359BBCF}"/>
              </a:ext>
            </a:extLst>
          </p:cNvPr>
          <p:cNvPicPr>
            <a:picLocks/>
          </p:cNvPicPr>
          <p:nvPr/>
        </p:nvPicPr>
        <p:blipFill rotWithShape="1"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24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78386" y="732515"/>
            <a:ext cx="1982885" cy="1382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Immagine 44" descr="Immagine che contiene pietra&#10;&#10;Descrizione generata automaticamente">
            <a:extLst>
              <a:ext uri="{FF2B5EF4-FFF2-40B4-BE49-F238E27FC236}">
                <a16:creationId xmlns:a16="http://schemas.microsoft.com/office/drawing/2014/main" id="{F893B7B5-0EB8-4A7C-B9DB-033200BB7C41}"/>
              </a:ext>
            </a:extLst>
          </p:cNvPr>
          <p:cNvPicPr>
            <a:picLocks/>
          </p:cNvPicPr>
          <p:nvPr/>
        </p:nvPicPr>
        <p:blipFill rotWithShape="1">
          <a:blip r:embed="rId4" cstate="hq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brightnessContrast bright="27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78386" y="2422724"/>
            <a:ext cx="1983600" cy="1382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Immagine 45">
            <a:extLst>
              <a:ext uri="{FF2B5EF4-FFF2-40B4-BE49-F238E27FC236}">
                <a16:creationId xmlns:a16="http://schemas.microsoft.com/office/drawing/2014/main" id="{DE7288C5-F1FE-4E41-973E-AB0E77719FE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brightnessContrast bright="24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612691" y="431947"/>
            <a:ext cx="1382396" cy="19835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Immagine 51">
            <a:extLst>
              <a:ext uri="{FF2B5EF4-FFF2-40B4-BE49-F238E27FC236}">
                <a16:creationId xmlns:a16="http://schemas.microsoft.com/office/drawing/2014/main" id="{CD7065AD-C586-4FB6-BC76-FC73F758A1EB}"/>
              </a:ext>
            </a:extLst>
          </p:cNvPr>
          <p:cNvPicPr>
            <a:picLocks/>
          </p:cNvPicPr>
          <p:nvPr/>
        </p:nvPicPr>
        <p:blipFill rotWithShape="1">
          <a:blip r:embed="rId8" cstate="hq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  <a14:imgEffect>
                      <a14:colorTemperature colorTemp="6200"/>
                    </a14:imgEffect>
                    <a14:imgEffect>
                      <a14:brightnessContrast brigh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2694550" y="431915"/>
            <a:ext cx="1382400" cy="198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Immagine 53" descr="Immagine che contiene cemento, pietra, sporco&#10;&#10;Descrizione generata automaticamente">
            <a:extLst>
              <a:ext uri="{FF2B5EF4-FFF2-40B4-BE49-F238E27FC236}">
                <a16:creationId xmlns:a16="http://schemas.microsoft.com/office/drawing/2014/main" id="{5D889CDB-4441-4BE2-8692-F40DE756DA73}"/>
              </a:ext>
            </a:extLst>
          </p:cNvPr>
          <p:cNvPicPr>
            <a:picLocks/>
          </p:cNvPicPr>
          <p:nvPr/>
        </p:nvPicPr>
        <p:blipFill rotWithShape="1">
          <a:blip r:embed="rId10" cstate="hq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  <a14:imgEffect>
                      <a14:colorTemperature colorTemp="6200"/>
                    </a14:imgEffect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612723" y="2122124"/>
            <a:ext cx="1382400" cy="198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Immagine 55">
            <a:extLst>
              <a:ext uri="{FF2B5EF4-FFF2-40B4-BE49-F238E27FC236}">
                <a16:creationId xmlns:a16="http://schemas.microsoft.com/office/drawing/2014/main" id="{B7665192-EC03-4E42-850D-D65AAF202535}"/>
              </a:ext>
            </a:extLst>
          </p:cNvPr>
          <p:cNvPicPr>
            <a:picLocks/>
          </p:cNvPicPr>
          <p:nvPr/>
        </p:nvPicPr>
        <p:blipFill rotWithShape="1">
          <a:blip r:embed="rId12" cstate="hq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25000"/>
                    </a14:imgEffect>
                    <a14:imgEffect>
                      <a14:brightnessContrast brigh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2393950" y="2422724"/>
            <a:ext cx="1983600" cy="1382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Immagine 57" descr="Immagine che contiene porcellana&#10;&#10;Descrizione generata automaticamente">
            <a:extLst>
              <a:ext uri="{FF2B5EF4-FFF2-40B4-BE49-F238E27FC236}">
                <a16:creationId xmlns:a16="http://schemas.microsoft.com/office/drawing/2014/main" id="{819FB50B-CFB1-4F0F-BB55-47AE9B534BBE}"/>
              </a:ext>
            </a:extLst>
          </p:cNvPr>
          <p:cNvPicPr>
            <a:picLocks/>
          </p:cNvPicPr>
          <p:nvPr/>
        </p:nvPicPr>
        <p:blipFill rotWithShape="1">
          <a:blip r:embed="rId14" cstate="hq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93950" y="4706937"/>
            <a:ext cx="1983600" cy="1382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Immagine 58" descr="Immagine che contiene porcellana, ceramica, blu, tessuto&#10;&#10;Descrizione generata automaticamente">
            <a:extLst>
              <a:ext uri="{FF2B5EF4-FFF2-40B4-BE49-F238E27FC236}">
                <a16:creationId xmlns:a16="http://schemas.microsoft.com/office/drawing/2014/main" id="{553763DE-EDF7-4165-A547-58F4266BD1B4}"/>
              </a:ext>
            </a:extLst>
          </p:cNvPr>
          <p:cNvPicPr>
            <a:picLocks/>
          </p:cNvPicPr>
          <p:nvPr/>
        </p:nvPicPr>
        <p:blipFill rotWithShape="1">
          <a:blip r:embed="rId16" cstate="hq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93950" y="6406981"/>
            <a:ext cx="1983600" cy="1382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Immagine 59" descr="Immagine che contiene ceramica, porcellana, tessuto&#10;&#10;Descrizione generata automaticamente">
            <a:extLst>
              <a:ext uri="{FF2B5EF4-FFF2-40B4-BE49-F238E27FC236}">
                <a16:creationId xmlns:a16="http://schemas.microsoft.com/office/drawing/2014/main" id="{A400E9C9-0494-4F02-9693-EE9ABA18DD2F}"/>
              </a:ext>
            </a:extLst>
          </p:cNvPr>
          <p:cNvPicPr>
            <a:picLocks/>
          </p:cNvPicPr>
          <p:nvPr/>
        </p:nvPicPr>
        <p:blipFill rotWithShape="1"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2123" y="6406981"/>
            <a:ext cx="1983600" cy="1382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Immagine 60" descr="Immagine che contiene blu, porcellana, tessuto&#10;&#10;Descrizione generata automaticamente">
            <a:extLst>
              <a:ext uri="{FF2B5EF4-FFF2-40B4-BE49-F238E27FC236}">
                <a16:creationId xmlns:a16="http://schemas.microsoft.com/office/drawing/2014/main" id="{DBC36E6E-09BF-4772-84FC-2C6528BC36E6}"/>
              </a:ext>
            </a:extLst>
          </p:cNvPr>
          <p:cNvPicPr>
            <a:picLocks/>
          </p:cNvPicPr>
          <p:nvPr/>
        </p:nvPicPr>
        <p:blipFill rotWithShape="1">
          <a:blip r:embed="rId19" cstate="hq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78386" y="6406981"/>
            <a:ext cx="1983600" cy="1382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Immagine 61" descr="Immagine che contiene ceramica, porcellana, tessuto&#10;&#10;Descrizione generata automaticamente">
            <a:extLst>
              <a:ext uri="{FF2B5EF4-FFF2-40B4-BE49-F238E27FC236}">
                <a16:creationId xmlns:a16="http://schemas.microsoft.com/office/drawing/2014/main" id="{527D575B-4B92-4429-BCBE-0B6BDB238E5D}"/>
              </a:ext>
            </a:extLst>
          </p:cNvPr>
          <p:cNvPicPr>
            <a:picLocks/>
          </p:cNvPicPr>
          <p:nvPr/>
        </p:nvPicPr>
        <p:blipFill rotWithShape="1">
          <a:blip r:embed="rId21" cstate="hq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4778986" y="4406337"/>
            <a:ext cx="1382400" cy="198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Immagine 62" descr="Immagine che contiene ceramica, blu, porcellana&#10;&#10;Descrizione generata automaticamente">
            <a:extLst>
              <a:ext uri="{FF2B5EF4-FFF2-40B4-BE49-F238E27FC236}">
                <a16:creationId xmlns:a16="http://schemas.microsoft.com/office/drawing/2014/main" id="{02936CB7-2708-481A-A782-01EE33F58C03}"/>
              </a:ext>
            </a:extLst>
          </p:cNvPr>
          <p:cNvPicPr>
            <a:picLocks/>
          </p:cNvPicPr>
          <p:nvPr/>
        </p:nvPicPr>
        <p:blipFill rotWithShape="1">
          <a:blip r:embed="rId23" cstate="hq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2123" y="4706937"/>
            <a:ext cx="1983600" cy="1382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Triangolo isoscele 33">
            <a:extLst>
              <a:ext uri="{FF2B5EF4-FFF2-40B4-BE49-F238E27FC236}">
                <a16:creationId xmlns:a16="http://schemas.microsoft.com/office/drawing/2014/main" id="{128C1010-BA11-48D9-A01E-F0425427D6CD}"/>
              </a:ext>
            </a:extLst>
          </p:cNvPr>
          <p:cNvSpPr/>
          <p:nvPr/>
        </p:nvSpPr>
        <p:spPr>
          <a:xfrm>
            <a:off x="1393507" y="1508379"/>
            <a:ext cx="73025" cy="11112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6" name="Triangolo isoscele 35">
            <a:extLst>
              <a:ext uri="{FF2B5EF4-FFF2-40B4-BE49-F238E27FC236}">
                <a16:creationId xmlns:a16="http://schemas.microsoft.com/office/drawing/2014/main" id="{26B5C16D-9185-46F0-8FB6-134643FCEDD3}"/>
              </a:ext>
            </a:extLst>
          </p:cNvPr>
          <p:cNvSpPr/>
          <p:nvPr/>
        </p:nvSpPr>
        <p:spPr>
          <a:xfrm rot="14408156">
            <a:off x="1445896" y="1652048"/>
            <a:ext cx="73025" cy="11112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38" name="Freccia in giù 37">
            <a:extLst>
              <a:ext uri="{FF2B5EF4-FFF2-40B4-BE49-F238E27FC236}">
                <a16:creationId xmlns:a16="http://schemas.microsoft.com/office/drawing/2014/main" id="{E5A861D4-606C-4920-9459-A4FFF1D5E3CF}"/>
              </a:ext>
            </a:extLst>
          </p:cNvPr>
          <p:cNvSpPr/>
          <p:nvPr/>
        </p:nvSpPr>
        <p:spPr>
          <a:xfrm rot="12653873">
            <a:off x="1410176" y="5315996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7" name="Freccia in giù 46">
            <a:extLst>
              <a:ext uri="{FF2B5EF4-FFF2-40B4-BE49-F238E27FC236}">
                <a16:creationId xmlns:a16="http://schemas.microsoft.com/office/drawing/2014/main" id="{85B65062-8C3C-4916-92B2-8971F77C7097}"/>
              </a:ext>
            </a:extLst>
          </p:cNvPr>
          <p:cNvSpPr/>
          <p:nvPr/>
        </p:nvSpPr>
        <p:spPr>
          <a:xfrm rot="12823229">
            <a:off x="1276828" y="5231858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5" name="Triangolo isoscele 54">
            <a:extLst>
              <a:ext uri="{FF2B5EF4-FFF2-40B4-BE49-F238E27FC236}">
                <a16:creationId xmlns:a16="http://schemas.microsoft.com/office/drawing/2014/main" id="{3D57AC8B-EC40-4AE1-9CD5-CED8C6E2043E}"/>
              </a:ext>
            </a:extLst>
          </p:cNvPr>
          <p:cNvSpPr/>
          <p:nvPr/>
        </p:nvSpPr>
        <p:spPr>
          <a:xfrm rot="14408156">
            <a:off x="3274696" y="1442498"/>
            <a:ext cx="73025" cy="11112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57" name="Triangolo isoscele 56">
            <a:extLst>
              <a:ext uri="{FF2B5EF4-FFF2-40B4-BE49-F238E27FC236}">
                <a16:creationId xmlns:a16="http://schemas.microsoft.com/office/drawing/2014/main" id="{3726EAF9-85A1-4CC6-BD2C-A11DC9246785}"/>
              </a:ext>
            </a:extLst>
          </p:cNvPr>
          <p:cNvSpPr/>
          <p:nvPr/>
        </p:nvSpPr>
        <p:spPr>
          <a:xfrm rot="14408156">
            <a:off x="5836920" y="1661574"/>
            <a:ext cx="73025" cy="11112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64" name="Triangolo isoscele 63">
            <a:extLst>
              <a:ext uri="{FF2B5EF4-FFF2-40B4-BE49-F238E27FC236}">
                <a16:creationId xmlns:a16="http://schemas.microsoft.com/office/drawing/2014/main" id="{4F1A639C-43E7-4934-B607-32231D3DE152}"/>
              </a:ext>
            </a:extLst>
          </p:cNvPr>
          <p:cNvSpPr/>
          <p:nvPr/>
        </p:nvSpPr>
        <p:spPr>
          <a:xfrm rot="14408156">
            <a:off x="4908232" y="3140332"/>
            <a:ext cx="73025" cy="11112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65" name="Triangolo isoscele 64">
            <a:extLst>
              <a:ext uri="{FF2B5EF4-FFF2-40B4-BE49-F238E27FC236}">
                <a16:creationId xmlns:a16="http://schemas.microsoft.com/office/drawing/2014/main" id="{D8413CC1-71AC-4EE4-9EFA-CA38C6DC96BF}"/>
              </a:ext>
            </a:extLst>
          </p:cNvPr>
          <p:cNvSpPr/>
          <p:nvPr/>
        </p:nvSpPr>
        <p:spPr>
          <a:xfrm rot="13134446">
            <a:off x="3574732" y="3407033"/>
            <a:ext cx="73025" cy="11112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66" name="Triangolo isoscele 65">
            <a:extLst>
              <a:ext uri="{FF2B5EF4-FFF2-40B4-BE49-F238E27FC236}">
                <a16:creationId xmlns:a16="http://schemas.microsoft.com/office/drawing/2014/main" id="{1DCF62AB-DB18-4975-B1D3-A4927A4816A4}"/>
              </a:ext>
            </a:extLst>
          </p:cNvPr>
          <p:cNvSpPr/>
          <p:nvPr/>
        </p:nvSpPr>
        <p:spPr>
          <a:xfrm rot="8916962">
            <a:off x="3941443" y="3473708"/>
            <a:ext cx="73025" cy="11112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67" name="Triangolo isoscele 66">
            <a:extLst>
              <a:ext uri="{FF2B5EF4-FFF2-40B4-BE49-F238E27FC236}">
                <a16:creationId xmlns:a16="http://schemas.microsoft.com/office/drawing/2014/main" id="{41261932-1368-4C43-8FD2-F6C9E5C36F22}"/>
              </a:ext>
            </a:extLst>
          </p:cNvPr>
          <p:cNvSpPr/>
          <p:nvPr/>
        </p:nvSpPr>
        <p:spPr>
          <a:xfrm rot="5178420">
            <a:off x="4165281" y="3347501"/>
            <a:ext cx="73025" cy="11112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68" name="Triangolo isoscele 67">
            <a:extLst>
              <a:ext uri="{FF2B5EF4-FFF2-40B4-BE49-F238E27FC236}">
                <a16:creationId xmlns:a16="http://schemas.microsoft.com/office/drawing/2014/main" id="{07C4ACC8-109B-4A86-872A-10E7EA9CCA1B}"/>
              </a:ext>
            </a:extLst>
          </p:cNvPr>
          <p:cNvSpPr/>
          <p:nvPr/>
        </p:nvSpPr>
        <p:spPr>
          <a:xfrm rot="2212822">
            <a:off x="2036443" y="3357027"/>
            <a:ext cx="73025" cy="11112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69" name="Freccia in giù 68">
            <a:extLst>
              <a:ext uri="{FF2B5EF4-FFF2-40B4-BE49-F238E27FC236}">
                <a16:creationId xmlns:a16="http://schemas.microsoft.com/office/drawing/2014/main" id="{12B91040-6E31-46CA-A5F9-BF02C0974B1F}"/>
              </a:ext>
            </a:extLst>
          </p:cNvPr>
          <p:cNvSpPr/>
          <p:nvPr/>
        </p:nvSpPr>
        <p:spPr>
          <a:xfrm rot="12653873">
            <a:off x="1541146" y="5401720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0" name="Freccia in giù 69">
            <a:extLst>
              <a:ext uri="{FF2B5EF4-FFF2-40B4-BE49-F238E27FC236}">
                <a16:creationId xmlns:a16="http://schemas.microsoft.com/office/drawing/2014/main" id="{A4201C88-8A7E-4E39-B220-8E9828508E83}"/>
              </a:ext>
            </a:extLst>
          </p:cNvPr>
          <p:cNvSpPr/>
          <p:nvPr/>
        </p:nvSpPr>
        <p:spPr>
          <a:xfrm rot="2101864">
            <a:off x="667226" y="4985003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1" name="Freccia in giù 70">
            <a:extLst>
              <a:ext uri="{FF2B5EF4-FFF2-40B4-BE49-F238E27FC236}">
                <a16:creationId xmlns:a16="http://schemas.microsoft.com/office/drawing/2014/main" id="{7925B283-2CC7-4FDA-A9B5-C0BF14E43CA4}"/>
              </a:ext>
            </a:extLst>
          </p:cNvPr>
          <p:cNvSpPr/>
          <p:nvPr/>
        </p:nvSpPr>
        <p:spPr>
          <a:xfrm rot="2271220">
            <a:off x="533878" y="4900865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2" name="Freccia in giù 71">
            <a:extLst>
              <a:ext uri="{FF2B5EF4-FFF2-40B4-BE49-F238E27FC236}">
                <a16:creationId xmlns:a16="http://schemas.microsoft.com/office/drawing/2014/main" id="{9DF15AE5-F862-45FF-BED0-B578926CFC79}"/>
              </a:ext>
            </a:extLst>
          </p:cNvPr>
          <p:cNvSpPr/>
          <p:nvPr/>
        </p:nvSpPr>
        <p:spPr>
          <a:xfrm rot="2101864">
            <a:off x="798196" y="5070727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3" name="Freccia in giù 72">
            <a:extLst>
              <a:ext uri="{FF2B5EF4-FFF2-40B4-BE49-F238E27FC236}">
                <a16:creationId xmlns:a16="http://schemas.microsoft.com/office/drawing/2014/main" id="{8FE6E4AD-08E0-46F2-BC02-CADAE45AFD9D}"/>
              </a:ext>
            </a:extLst>
          </p:cNvPr>
          <p:cNvSpPr/>
          <p:nvPr/>
        </p:nvSpPr>
        <p:spPr>
          <a:xfrm rot="20584365">
            <a:off x="3267550" y="5611274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4" name="Freccia in giù 73">
            <a:extLst>
              <a:ext uri="{FF2B5EF4-FFF2-40B4-BE49-F238E27FC236}">
                <a16:creationId xmlns:a16="http://schemas.microsoft.com/office/drawing/2014/main" id="{4421FDB6-9FE6-4DFF-90B4-6E8DD0C577BA}"/>
              </a:ext>
            </a:extLst>
          </p:cNvPr>
          <p:cNvSpPr/>
          <p:nvPr/>
        </p:nvSpPr>
        <p:spPr>
          <a:xfrm rot="20753721">
            <a:off x="3084196" y="5662866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5" name="Freccia in giù 74">
            <a:extLst>
              <a:ext uri="{FF2B5EF4-FFF2-40B4-BE49-F238E27FC236}">
                <a16:creationId xmlns:a16="http://schemas.microsoft.com/office/drawing/2014/main" id="{8D90743C-D055-41C8-95FF-20FFA1A111AE}"/>
              </a:ext>
            </a:extLst>
          </p:cNvPr>
          <p:cNvSpPr/>
          <p:nvPr/>
        </p:nvSpPr>
        <p:spPr>
          <a:xfrm rot="20584365">
            <a:off x="3477101" y="5535073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6" name="Freccia in giù 75">
            <a:extLst>
              <a:ext uri="{FF2B5EF4-FFF2-40B4-BE49-F238E27FC236}">
                <a16:creationId xmlns:a16="http://schemas.microsoft.com/office/drawing/2014/main" id="{6F7EA9FF-BA1D-4039-ABC3-3DFB2CF8EEFB}"/>
              </a:ext>
            </a:extLst>
          </p:cNvPr>
          <p:cNvSpPr/>
          <p:nvPr/>
        </p:nvSpPr>
        <p:spPr>
          <a:xfrm rot="13228003">
            <a:off x="5170169" y="5237418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7" name="Freccia in giù 76">
            <a:extLst>
              <a:ext uri="{FF2B5EF4-FFF2-40B4-BE49-F238E27FC236}">
                <a16:creationId xmlns:a16="http://schemas.microsoft.com/office/drawing/2014/main" id="{7DCEB5F8-7278-448D-9FCF-A4312FEEEAC3}"/>
              </a:ext>
            </a:extLst>
          </p:cNvPr>
          <p:cNvSpPr/>
          <p:nvPr/>
        </p:nvSpPr>
        <p:spPr>
          <a:xfrm rot="13397359">
            <a:off x="5036820" y="5146135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8" name="Freccia in giù 77">
            <a:extLst>
              <a:ext uri="{FF2B5EF4-FFF2-40B4-BE49-F238E27FC236}">
                <a16:creationId xmlns:a16="http://schemas.microsoft.com/office/drawing/2014/main" id="{00296738-7994-4E61-93EA-A06CE6B85535}"/>
              </a:ext>
            </a:extLst>
          </p:cNvPr>
          <p:cNvSpPr/>
          <p:nvPr/>
        </p:nvSpPr>
        <p:spPr>
          <a:xfrm rot="13228003">
            <a:off x="5293995" y="5335048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9" name="Freccia in giù 78">
            <a:extLst>
              <a:ext uri="{FF2B5EF4-FFF2-40B4-BE49-F238E27FC236}">
                <a16:creationId xmlns:a16="http://schemas.microsoft.com/office/drawing/2014/main" id="{4745A283-F96F-4EDB-A6B3-86A2DC2EEF45}"/>
              </a:ext>
            </a:extLst>
          </p:cNvPr>
          <p:cNvSpPr/>
          <p:nvPr/>
        </p:nvSpPr>
        <p:spPr>
          <a:xfrm rot="20462205">
            <a:off x="5891689" y="7049547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0" name="Freccia in giù 79">
            <a:extLst>
              <a:ext uri="{FF2B5EF4-FFF2-40B4-BE49-F238E27FC236}">
                <a16:creationId xmlns:a16="http://schemas.microsoft.com/office/drawing/2014/main" id="{E2144317-F548-4E8C-927B-DBB93E8608F3}"/>
              </a:ext>
            </a:extLst>
          </p:cNvPr>
          <p:cNvSpPr/>
          <p:nvPr/>
        </p:nvSpPr>
        <p:spPr>
          <a:xfrm rot="20631561">
            <a:off x="5672613" y="7101140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1" name="Freccia in giù 80">
            <a:extLst>
              <a:ext uri="{FF2B5EF4-FFF2-40B4-BE49-F238E27FC236}">
                <a16:creationId xmlns:a16="http://schemas.microsoft.com/office/drawing/2014/main" id="{81B4F0C3-F224-4112-B4FE-973C60A33C3D}"/>
              </a:ext>
            </a:extLst>
          </p:cNvPr>
          <p:cNvSpPr/>
          <p:nvPr/>
        </p:nvSpPr>
        <p:spPr>
          <a:xfrm rot="20462205">
            <a:off x="6086951" y="6973347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2" name="Freccia in giù 81">
            <a:extLst>
              <a:ext uri="{FF2B5EF4-FFF2-40B4-BE49-F238E27FC236}">
                <a16:creationId xmlns:a16="http://schemas.microsoft.com/office/drawing/2014/main" id="{D1BB0DC3-C8D1-41F2-97B6-D60DF33D467F}"/>
              </a:ext>
            </a:extLst>
          </p:cNvPr>
          <p:cNvSpPr/>
          <p:nvPr/>
        </p:nvSpPr>
        <p:spPr>
          <a:xfrm rot="20462205">
            <a:off x="3272313" y="7216234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3" name="Freccia in giù 82">
            <a:extLst>
              <a:ext uri="{FF2B5EF4-FFF2-40B4-BE49-F238E27FC236}">
                <a16:creationId xmlns:a16="http://schemas.microsoft.com/office/drawing/2014/main" id="{B2D73C1F-989E-4A78-98C8-DE4CA4A6E140}"/>
              </a:ext>
            </a:extLst>
          </p:cNvPr>
          <p:cNvSpPr/>
          <p:nvPr/>
        </p:nvSpPr>
        <p:spPr>
          <a:xfrm rot="20631561">
            <a:off x="3072288" y="7258302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5" name="Freccia in giù 84">
            <a:extLst>
              <a:ext uri="{FF2B5EF4-FFF2-40B4-BE49-F238E27FC236}">
                <a16:creationId xmlns:a16="http://schemas.microsoft.com/office/drawing/2014/main" id="{719BA899-4FFB-4AD0-9DAF-96FF31C9FE60}"/>
              </a:ext>
            </a:extLst>
          </p:cNvPr>
          <p:cNvSpPr/>
          <p:nvPr/>
        </p:nvSpPr>
        <p:spPr>
          <a:xfrm rot="10595036">
            <a:off x="1431606" y="7001920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6" name="Freccia in giù 85">
            <a:extLst>
              <a:ext uri="{FF2B5EF4-FFF2-40B4-BE49-F238E27FC236}">
                <a16:creationId xmlns:a16="http://schemas.microsoft.com/office/drawing/2014/main" id="{68A4E65B-C152-4211-A82F-78D648F2EB4B}"/>
              </a:ext>
            </a:extLst>
          </p:cNvPr>
          <p:cNvSpPr/>
          <p:nvPr/>
        </p:nvSpPr>
        <p:spPr>
          <a:xfrm rot="10764392">
            <a:off x="1219677" y="6984458"/>
            <a:ext cx="66675" cy="1016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90626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9F67B8E3-80E2-43EF-A1B2-3304490890AF}"/>
              </a:ext>
            </a:extLst>
          </p:cNvPr>
          <p:cNvSpPr txBox="1"/>
          <p:nvPr/>
        </p:nvSpPr>
        <p:spPr>
          <a:xfrm>
            <a:off x="1007845" y="1361163"/>
            <a:ext cx="3256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3B7FD556-4D4E-49B5-89F0-F9BA9D7262AD}"/>
              </a:ext>
            </a:extLst>
          </p:cNvPr>
          <p:cNvSpPr txBox="1"/>
          <p:nvPr/>
        </p:nvSpPr>
        <p:spPr>
          <a:xfrm rot="10800000" flipV="1">
            <a:off x="3281816" y="1397739"/>
            <a:ext cx="43709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491B002-5764-44C7-8B7E-4C205054F9E2}"/>
              </a:ext>
            </a:extLst>
          </p:cNvPr>
          <p:cNvSpPr txBox="1"/>
          <p:nvPr/>
        </p:nvSpPr>
        <p:spPr>
          <a:xfrm rot="10800000" flipV="1">
            <a:off x="1086191" y="4122830"/>
            <a:ext cx="3024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787ED12A-69BF-4B2E-A9DB-F894318196E0}"/>
              </a:ext>
            </a:extLst>
          </p:cNvPr>
          <p:cNvSpPr txBox="1"/>
          <p:nvPr/>
        </p:nvSpPr>
        <p:spPr>
          <a:xfrm rot="10800000" flipV="1">
            <a:off x="3403737" y="4136841"/>
            <a:ext cx="3779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F33F8D01-0B9F-47EA-A6F1-96BAA0DF92A4}"/>
              </a:ext>
            </a:extLst>
          </p:cNvPr>
          <p:cNvSpPr txBox="1"/>
          <p:nvPr/>
        </p:nvSpPr>
        <p:spPr>
          <a:xfrm>
            <a:off x="6248400" y="9696450"/>
            <a:ext cx="66891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13" dirty="0"/>
              <a:t>Figure S4</a:t>
            </a:r>
          </a:p>
        </p:txBody>
      </p:sp>
      <p:graphicFrame>
        <p:nvGraphicFramePr>
          <p:cNvPr id="11" name="Object 4">
            <a:extLst>
              <a:ext uri="{FF2B5EF4-FFF2-40B4-BE49-F238E27FC236}">
                <a16:creationId xmlns:a16="http://schemas.microsoft.com/office/drawing/2014/main" id="{53BECABC-FCE0-4853-B58F-DB03125F66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2657826"/>
              </p:ext>
            </p:extLst>
          </p:nvPr>
        </p:nvGraphicFramePr>
        <p:xfrm>
          <a:off x="1042702" y="1737487"/>
          <a:ext cx="2482505" cy="23624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" name="Prism 9" r:id="rId3" imgW="3310007" imgH="3149907" progId="Prism9.Document">
                  <p:embed/>
                </p:oleObj>
              </mc:Choice>
              <mc:Fallback>
                <p:oleObj name="Prism 9" r:id="rId3" imgW="3310007" imgH="3149907" progId="Prism9.Document">
                  <p:embed/>
                  <p:pic>
                    <p:nvPicPr>
                      <p:cNvPr id="9" name="Object 4">
                        <a:extLst>
                          <a:ext uri="{FF2B5EF4-FFF2-40B4-BE49-F238E27FC236}">
                            <a16:creationId xmlns:a16="http://schemas.microsoft.com/office/drawing/2014/main" id="{9B6AA27A-E402-4DE8-B991-A90C6222FB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42702" y="1737487"/>
                        <a:ext cx="2482505" cy="23624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4">
            <a:extLst>
              <a:ext uri="{FF2B5EF4-FFF2-40B4-BE49-F238E27FC236}">
                <a16:creationId xmlns:a16="http://schemas.microsoft.com/office/drawing/2014/main" id="{EE80D8CB-26E6-4AE5-8AE7-5A4BEB8BFC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9682787"/>
              </p:ext>
            </p:extLst>
          </p:nvPr>
        </p:nvGraphicFramePr>
        <p:xfrm>
          <a:off x="1043845" y="4461065"/>
          <a:ext cx="2482505" cy="23624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7" name="Prism 9" r:id="rId5" imgW="3310007" imgH="3149907" progId="Prism9.Document">
                  <p:embed/>
                </p:oleObj>
              </mc:Choice>
              <mc:Fallback>
                <p:oleObj name="Prism 9" r:id="rId5" imgW="3310007" imgH="3149907" progId="Prism9.Document">
                  <p:embed/>
                  <p:pic>
                    <p:nvPicPr>
                      <p:cNvPr id="10" name="Object 4">
                        <a:extLst>
                          <a:ext uri="{FF2B5EF4-FFF2-40B4-BE49-F238E27FC236}">
                            <a16:creationId xmlns:a16="http://schemas.microsoft.com/office/drawing/2014/main" id="{C1829FB5-25B4-4893-A80D-30665F1D44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43845" y="4461065"/>
                        <a:ext cx="2482505" cy="23624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4">
            <a:extLst>
              <a:ext uri="{FF2B5EF4-FFF2-40B4-BE49-F238E27FC236}">
                <a16:creationId xmlns:a16="http://schemas.microsoft.com/office/drawing/2014/main" id="{0ABCC63B-9136-462A-9750-82E0ACF494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2222917"/>
              </p:ext>
            </p:extLst>
          </p:nvPr>
        </p:nvGraphicFramePr>
        <p:xfrm>
          <a:off x="3303302" y="1742249"/>
          <a:ext cx="2482505" cy="23624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8" name="Prism 9" r:id="rId7" imgW="3310007" imgH="3149907" progId="Prism9.Document">
                  <p:embed/>
                </p:oleObj>
              </mc:Choice>
              <mc:Fallback>
                <p:oleObj name="Prism 9" r:id="rId7" imgW="3310007" imgH="3149907" progId="Prism9.Document">
                  <p:embed/>
                  <p:pic>
                    <p:nvPicPr>
                      <p:cNvPr id="11" name="Object 4">
                        <a:extLst>
                          <a:ext uri="{FF2B5EF4-FFF2-40B4-BE49-F238E27FC236}">
                            <a16:creationId xmlns:a16="http://schemas.microsoft.com/office/drawing/2014/main" id="{17557901-03E6-4CB8-A25C-8005AB8988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03302" y="1742249"/>
                        <a:ext cx="2482505" cy="23624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4">
            <a:extLst>
              <a:ext uri="{FF2B5EF4-FFF2-40B4-BE49-F238E27FC236}">
                <a16:creationId xmlns:a16="http://schemas.microsoft.com/office/drawing/2014/main" id="{A57D9143-948E-4310-BF61-29E8E16022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4304359"/>
              </p:ext>
            </p:extLst>
          </p:nvPr>
        </p:nvGraphicFramePr>
        <p:xfrm>
          <a:off x="3305969" y="4489704"/>
          <a:ext cx="2478088" cy="2420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9" name="Prism 9" r:id="rId9" imgW="3305326" imgH="3229141" progId="Prism9.Document">
                  <p:embed/>
                </p:oleObj>
              </mc:Choice>
              <mc:Fallback>
                <p:oleObj name="Prism 9" r:id="rId9" imgW="3305326" imgH="3229141" progId="Prism9.Document">
                  <p:embed/>
                  <p:pic>
                    <p:nvPicPr>
                      <p:cNvPr id="12" name="Object 4">
                        <a:extLst>
                          <a:ext uri="{FF2B5EF4-FFF2-40B4-BE49-F238E27FC236}">
                            <a16:creationId xmlns:a16="http://schemas.microsoft.com/office/drawing/2014/main" id="{28CB5ABA-F00C-4F59-B56B-8CF8308754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305969" y="4489704"/>
                        <a:ext cx="2478088" cy="2420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608240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F33F8D01-0B9F-47EA-A6F1-96BAA0DF92A4}"/>
              </a:ext>
            </a:extLst>
          </p:cNvPr>
          <p:cNvSpPr txBox="1"/>
          <p:nvPr/>
        </p:nvSpPr>
        <p:spPr>
          <a:xfrm>
            <a:off x="6248400" y="9696450"/>
            <a:ext cx="66891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13" dirty="0"/>
              <a:t>Figure S5</a:t>
            </a:r>
          </a:p>
        </p:txBody>
      </p:sp>
      <p:graphicFrame>
        <p:nvGraphicFramePr>
          <p:cNvPr id="29" name="Object 4">
            <a:extLst>
              <a:ext uri="{FF2B5EF4-FFF2-40B4-BE49-F238E27FC236}">
                <a16:creationId xmlns:a16="http://schemas.microsoft.com/office/drawing/2014/main" id="{810FAB01-5320-46E9-BD35-5F89751672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4038826"/>
              </p:ext>
            </p:extLst>
          </p:nvPr>
        </p:nvGraphicFramePr>
        <p:xfrm>
          <a:off x="5434013" y="159830"/>
          <a:ext cx="1206500" cy="240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0" name="Prism 9" r:id="rId3" imgW="1588559" imgH="3162152" progId="Prism9.Document">
                  <p:embed/>
                </p:oleObj>
              </mc:Choice>
              <mc:Fallback>
                <p:oleObj name="Prism 9" r:id="rId3" imgW="1588559" imgH="3162152" progId="Prism9.Document">
                  <p:embed/>
                  <p:pic>
                    <p:nvPicPr>
                      <p:cNvPr id="19" name="Object 4">
                        <a:extLst>
                          <a:ext uri="{FF2B5EF4-FFF2-40B4-BE49-F238E27FC236}">
                            <a16:creationId xmlns:a16="http://schemas.microsoft.com/office/drawing/2014/main" id="{A181E2B7-AED1-4CB7-A993-B137512A5E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434013" y="159830"/>
                        <a:ext cx="1206500" cy="240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4">
            <a:extLst>
              <a:ext uri="{FF2B5EF4-FFF2-40B4-BE49-F238E27FC236}">
                <a16:creationId xmlns:a16="http://schemas.microsoft.com/office/drawing/2014/main" id="{EF07EA81-3270-402F-9E59-6A0D61FD35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3747687"/>
              </p:ext>
            </p:extLst>
          </p:nvPr>
        </p:nvGraphicFramePr>
        <p:xfrm>
          <a:off x="3981450" y="166688"/>
          <a:ext cx="1314450" cy="2411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1" name="Prism 9" r:id="rId5" imgW="1730452" imgH="3162152" progId="Prism9.Document">
                  <p:embed/>
                </p:oleObj>
              </mc:Choice>
              <mc:Fallback>
                <p:oleObj name="Prism 9" r:id="rId5" imgW="1730452" imgH="3162152" progId="Prism9.Document">
                  <p:embed/>
                  <p:pic>
                    <p:nvPicPr>
                      <p:cNvPr id="20" name="Object 4">
                        <a:extLst>
                          <a:ext uri="{FF2B5EF4-FFF2-40B4-BE49-F238E27FC236}">
                            <a16:creationId xmlns:a16="http://schemas.microsoft.com/office/drawing/2014/main" id="{B1410CA1-EE69-4CFC-A197-79900AE7A4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81450" y="166688"/>
                        <a:ext cx="1314450" cy="2411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1" name="Immagine 30" descr="Immagine che contiene sedendo, largo, tavolo, frutta&#10;&#10;Descrizione generata automaticamente">
            <a:extLst>
              <a:ext uri="{FF2B5EF4-FFF2-40B4-BE49-F238E27FC236}">
                <a16:creationId xmlns:a16="http://schemas.microsoft.com/office/drawing/2014/main" id="{7CE39BE8-9E77-41DC-B500-46037047C682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colorTemperature colorTemp="7200"/>
                    </a14:imgEffect>
                    <a14:imgEffect>
                      <a14:saturation sat="60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1370576" y="627390"/>
            <a:ext cx="1232741" cy="112485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2" name="Immagine 31" descr="Immagine che contiene viola, sedendo, tenendo, giocatore&#10;&#10;Descrizione generata automaticamente">
            <a:extLst>
              <a:ext uri="{FF2B5EF4-FFF2-40B4-BE49-F238E27FC236}">
                <a16:creationId xmlns:a16="http://schemas.microsoft.com/office/drawing/2014/main" id="{A3333440-383B-4457-9335-3D24C460CCAA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colorTemperature colorTemp="8800"/>
                    </a14:imgEffect>
                    <a14:imgEffect>
                      <a14:saturation sat="66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2679834" y="628596"/>
            <a:ext cx="1229479" cy="112244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3" name="Immagine 32" descr="Immagine che contiene edificio, esterni, mattone, frutta&#10;&#10;Descrizione generata automaticamente">
            <a:extLst>
              <a:ext uri="{FF2B5EF4-FFF2-40B4-BE49-F238E27FC236}">
                <a16:creationId xmlns:a16="http://schemas.microsoft.com/office/drawing/2014/main" id="{60F69DCC-5C0C-4844-9C59-3173E531AA31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colorTemperature colorTemp="8800"/>
                    </a14:imgEffect>
                    <a14:imgEffect>
                      <a14:saturation sat="76000"/>
                    </a14:imgEffect>
                    <a14:imgEffect>
                      <a14:brightnessContrast bright="5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73547" y="626293"/>
            <a:ext cx="1220512" cy="112704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432ECE89-D5B0-490C-A81A-57E52F244198}"/>
              </a:ext>
            </a:extLst>
          </p:cNvPr>
          <p:cNvSpPr txBox="1"/>
          <p:nvPr/>
        </p:nvSpPr>
        <p:spPr>
          <a:xfrm>
            <a:off x="3883199" y="29874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66DDF80D-1C84-43DD-B8AC-D14D64604A8A}"/>
              </a:ext>
            </a:extLst>
          </p:cNvPr>
          <p:cNvSpPr txBox="1"/>
          <p:nvPr/>
        </p:nvSpPr>
        <p:spPr>
          <a:xfrm>
            <a:off x="5167533" y="29874"/>
            <a:ext cx="4744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D7CF116A-CF78-4B4B-8127-A3B477CD20C9}"/>
              </a:ext>
            </a:extLst>
          </p:cNvPr>
          <p:cNvSpPr txBox="1"/>
          <p:nvPr/>
        </p:nvSpPr>
        <p:spPr>
          <a:xfrm>
            <a:off x="-24557" y="29874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37" name="Gruppo 36">
            <a:extLst>
              <a:ext uri="{FF2B5EF4-FFF2-40B4-BE49-F238E27FC236}">
                <a16:creationId xmlns:a16="http://schemas.microsoft.com/office/drawing/2014/main" id="{E6D1F12D-2FB0-4628-9081-E79E1A7817A0}"/>
              </a:ext>
            </a:extLst>
          </p:cNvPr>
          <p:cNvGrpSpPr/>
          <p:nvPr/>
        </p:nvGrpSpPr>
        <p:grpSpPr>
          <a:xfrm>
            <a:off x="465117" y="83457"/>
            <a:ext cx="3274694" cy="551536"/>
            <a:chOff x="465117" y="144417"/>
            <a:chExt cx="3274694" cy="551536"/>
          </a:xfrm>
        </p:grpSpPr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64DB90FD-D724-48E6-AB77-DA199F40990A}"/>
                </a:ext>
              </a:extLst>
            </p:cNvPr>
            <p:cNvSpPr txBox="1"/>
            <p:nvPr/>
          </p:nvSpPr>
          <p:spPr>
            <a:xfrm>
              <a:off x="465117" y="418954"/>
              <a:ext cx="483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1ED26951-4EF0-46F8-8ED1-B81AB00D0DB3}"/>
                </a:ext>
              </a:extLst>
            </p:cNvPr>
            <p:cNvSpPr txBox="1"/>
            <p:nvPr/>
          </p:nvSpPr>
          <p:spPr>
            <a:xfrm>
              <a:off x="1798617" y="390379"/>
              <a:ext cx="483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4E9634E2-A112-4A73-A875-8D555601F449}"/>
                </a:ext>
              </a:extLst>
            </p:cNvPr>
            <p:cNvSpPr txBox="1"/>
            <p:nvPr/>
          </p:nvSpPr>
          <p:spPr>
            <a:xfrm>
              <a:off x="2968287" y="418954"/>
              <a:ext cx="7715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Lcn2Ab</a:t>
              </a:r>
            </a:p>
          </p:txBody>
        </p:sp>
        <p:cxnSp>
          <p:nvCxnSpPr>
            <p:cNvPr id="41" name="Connettore diritto 40">
              <a:extLst>
                <a:ext uri="{FF2B5EF4-FFF2-40B4-BE49-F238E27FC236}">
                  <a16:creationId xmlns:a16="http://schemas.microsoft.com/office/drawing/2014/main" id="{ECB7F83D-9163-4047-9B40-BC2A4AD95AA7}"/>
                </a:ext>
              </a:extLst>
            </p:cNvPr>
            <p:cNvCxnSpPr/>
            <p:nvPr/>
          </p:nvCxnSpPr>
          <p:spPr>
            <a:xfrm>
              <a:off x="2025311" y="412439"/>
              <a:ext cx="13430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C27E61F7-A17A-4663-9B3D-17EC233183C5}"/>
                </a:ext>
              </a:extLst>
            </p:cNvPr>
            <p:cNvSpPr txBox="1"/>
            <p:nvPr/>
          </p:nvSpPr>
          <p:spPr>
            <a:xfrm>
              <a:off x="2444410" y="144417"/>
              <a:ext cx="5619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DX</a:t>
              </a:r>
            </a:p>
          </p:txBody>
        </p:sp>
      </p:grpSp>
      <p:graphicFrame>
        <p:nvGraphicFramePr>
          <p:cNvPr id="43" name="Object 4">
            <a:extLst>
              <a:ext uri="{FF2B5EF4-FFF2-40B4-BE49-F238E27FC236}">
                <a16:creationId xmlns:a16="http://schemas.microsoft.com/office/drawing/2014/main" id="{64B6B6B7-768B-4B33-B786-E17FC08565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7807405"/>
              </p:ext>
            </p:extLst>
          </p:nvPr>
        </p:nvGraphicFramePr>
        <p:xfrm>
          <a:off x="5288471" y="2757615"/>
          <a:ext cx="1352550" cy="2403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2" name="Prism 9" r:id="rId13" imgW="1780871" imgH="3162152" progId="Prism9.Document">
                  <p:embed/>
                </p:oleObj>
              </mc:Choice>
              <mc:Fallback>
                <p:oleObj name="Prism 9" r:id="rId13" imgW="1780871" imgH="3162152" progId="Prism9.Document">
                  <p:embed/>
                  <p:pic>
                    <p:nvPicPr>
                      <p:cNvPr id="33" name="Object 4">
                        <a:extLst>
                          <a:ext uri="{FF2B5EF4-FFF2-40B4-BE49-F238E27FC236}">
                            <a16:creationId xmlns:a16="http://schemas.microsoft.com/office/drawing/2014/main" id="{0D1C43DF-0775-4069-9484-78E196D1E1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288471" y="2757615"/>
                        <a:ext cx="1352550" cy="2403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4" name="Immagine 43" descr="Immagine che contiene maglietta&#10;&#10;Descrizione generata automaticamente">
            <a:extLst>
              <a:ext uri="{FF2B5EF4-FFF2-40B4-BE49-F238E27FC236}">
                <a16:creationId xmlns:a16="http://schemas.microsoft.com/office/drawing/2014/main" id="{3CE82E9E-3E01-4194-9266-DBF29BEA7585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  <a14:imgEffect>
                      <a14:colorTemperature colorTemp="7200"/>
                    </a14:imgEffect>
                    <a14:imgEffect>
                      <a14:saturation sat="66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780" y="3132798"/>
            <a:ext cx="1231104" cy="11353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5" name="Immagine 44" descr="Immagine che contiene torta, viola&#10;&#10;Descrizione generata automaticamente">
            <a:extLst>
              <a:ext uri="{FF2B5EF4-FFF2-40B4-BE49-F238E27FC236}">
                <a16:creationId xmlns:a16="http://schemas.microsoft.com/office/drawing/2014/main" id="{0FA33C03-352A-4A39-88F9-8452C38A48A9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50000"/>
                    </a14:imgEffect>
                    <a14:imgEffect>
                      <a14:saturation sat="56000"/>
                    </a14:imgEffect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73011" y="3137087"/>
            <a:ext cx="1236662" cy="113260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6" name="Immagine 45" descr="Immagine che contiene erba, esterni, campo, sedendo&#10;&#10;Descrizione generata automaticamente">
            <a:extLst>
              <a:ext uri="{FF2B5EF4-FFF2-40B4-BE49-F238E27FC236}">
                <a16:creationId xmlns:a16="http://schemas.microsoft.com/office/drawing/2014/main" id="{6808C370-664A-42DA-A59E-9594438B8EDF}"/>
              </a:ext>
            </a:extLst>
          </p:cNvPr>
          <p:cNvPicPr>
            <a:picLocks noChangeAspect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colorTemperature colorTemp="5900"/>
                    </a14:imgEffect>
                    <a14:imgEffect>
                      <a14:saturation sat="70000"/>
                    </a14:imgEffect>
                    <a14:imgEffect>
                      <a14:brightnessContrast brigh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60942" y="3132323"/>
            <a:ext cx="1239840" cy="113585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47" name="Object 4">
            <a:extLst>
              <a:ext uri="{FF2B5EF4-FFF2-40B4-BE49-F238E27FC236}">
                <a16:creationId xmlns:a16="http://schemas.microsoft.com/office/drawing/2014/main" id="{C245E065-FEF5-4315-A0A7-B58D7AF04F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7847589"/>
              </p:ext>
            </p:extLst>
          </p:nvPr>
        </p:nvGraphicFramePr>
        <p:xfrm>
          <a:off x="3981958" y="2633663"/>
          <a:ext cx="1312863" cy="2528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" name="Prism 9" r:id="rId21" imgW="1730452" imgH="3316298" progId="Prism9.Document">
                  <p:embed/>
                </p:oleObj>
              </mc:Choice>
              <mc:Fallback>
                <p:oleObj name="Prism 9" r:id="rId21" imgW="1730452" imgH="3316298" progId="Prism9.Document">
                  <p:embed/>
                  <p:pic>
                    <p:nvPicPr>
                      <p:cNvPr id="37" name="Object 4">
                        <a:extLst>
                          <a:ext uri="{FF2B5EF4-FFF2-40B4-BE49-F238E27FC236}">
                            <a16:creationId xmlns:a16="http://schemas.microsoft.com/office/drawing/2014/main" id="{38BF4E25-A12C-497D-B88B-4765E70F64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981958" y="2633663"/>
                        <a:ext cx="1312863" cy="2528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E83C6127-0E73-4F36-B9DA-258F9E96DD1D}"/>
              </a:ext>
            </a:extLst>
          </p:cNvPr>
          <p:cNvSpPr txBox="1"/>
          <p:nvPr/>
        </p:nvSpPr>
        <p:spPr>
          <a:xfrm>
            <a:off x="5167533" y="2520818"/>
            <a:ext cx="4042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B5A6E697-AD23-451A-A6A8-868080F8B815}"/>
              </a:ext>
            </a:extLst>
          </p:cNvPr>
          <p:cNvSpPr txBox="1"/>
          <p:nvPr/>
        </p:nvSpPr>
        <p:spPr>
          <a:xfrm>
            <a:off x="3897187" y="2520818"/>
            <a:ext cx="4095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8FB3E8B5-BEFC-40B6-A303-AC8956F64D06}"/>
              </a:ext>
            </a:extLst>
          </p:cNvPr>
          <p:cNvSpPr txBox="1"/>
          <p:nvPr/>
        </p:nvSpPr>
        <p:spPr>
          <a:xfrm>
            <a:off x="-28740" y="2520818"/>
            <a:ext cx="4443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51" name="Gruppo 50">
            <a:extLst>
              <a:ext uri="{FF2B5EF4-FFF2-40B4-BE49-F238E27FC236}">
                <a16:creationId xmlns:a16="http://schemas.microsoft.com/office/drawing/2014/main" id="{DE85DCD7-1E89-4B57-84C2-3DFE474A24FB}"/>
              </a:ext>
            </a:extLst>
          </p:cNvPr>
          <p:cNvGrpSpPr/>
          <p:nvPr/>
        </p:nvGrpSpPr>
        <p:grpSpPr>
          <a:xfrm>
            <a:off x="473133" y="2594051"/>
            <a:ext cx="3274694" cy="551536"/>
            <a:chOff x="465117" y="144417"/>
            <a:chExt cx="3274694" cy="551536"/>
          </a:xfrm>
        </p:grpSpPr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0E2C8587-8B3F-4668-8900-2311A2022E0B}"/>
                </a:ext>
              </a:extLst>
            </p:cNvPr>
            <p:cNvSpPr txBox="1"/>
            <p:nvPr/>
          </p:nvSpPr>
          <p:spPr>
            <a:xfrm>
              <a:off x="465117" y="418954"/>
              <a:ext cx="483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8AFAC313-5E52-481A-97B2-2AD59344D5C3}"/>
                </a:ext>
              </a:extLst>
            </p:cNvPr>
            <p:cNvSpPr txBox="1"/>
            <p:nvPr/>
          </p:nvSpPr>
          <p:spPr>
            <a:xfrm>
              <a:off x="1798617" y="390379"/>
              <a:ext cx="483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CasellaDiTesto 53">
              <a:extLst>
                <a:ext uri="{FF2B5EF4-FFF2-40B4-BE49-F238E27FC236}">
                  <a16:creationId xmlns:a16="http://schemas.microsoft.com/office/drawing/2014/main" id="{24377DCC-26CD-4C95-95B2-C830F6CFC02E}"/>
                </a:ext>
              </a:extLst>
            </p:cNvPr>
            <p:cNvSpPr txBox="1"/>
            <p:nvPr/>
          </p:nvSpPr>
          <p:spPr>
            <a:xfrm>
              <a:off x="2968287" y="418954"/>
              <a:ext cx="7715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Lcn2Ab</a:t>
              </a:r>
            </a:p>
          </p:txBody>
        </p:sp>
        <p:cxnSp>
          <p:nvCxnSpPr>
            <p:cNvPr id="55" name="Connettore diritto 54">
              <a:extLst>
                <a:ext uri="{FF2B5EF4-FFF2-40B4-BE49-F238E27FC236}">
                  <a16:creationId xmlns:a16="http://schemas.microsoft.com/office/drawing/2014/main" id="{1D3C42FF-1573-429E-A7A0-0591CF152785}"/>
                </a:ext>
              </a:extLst>
            </p:cNvPr>
            <p:cNvCxnSpPr/>
            <p:nvPr/>
          </p:nvCxnSpPr>
          <p:spPr>
            <a:xfrm>
              <a:off x="2025311" y="412439"/>
              <a:ext cx="13430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189D1CED-84AD-4069-BAB8-56F33F948A3E}"/>
                </a:ext>
              </a:extLst>
            </p:cNvPr>
            <p:cNvSpPr txBox="1"/>
            <p:nvPr/>
          </p:nvSpPr>
          <p:spPr>
            <a:xfrm>
              <a:off x="2444410" y="144417"/>
              <a:ext cx="5619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D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657939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6</Words>
  <Application>Microsoft Office PowerPoint</Application>
  <PresentationFormat>A4 (21x29,7 cm)</PresentationFormat>
  <Paragraphs>52</Paragraphs>
  <Slides>5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3</vt:i4>
      </vt:variant>
      <vt:variant>
        <vt:lpstr>Titoli diapositive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Tema di Office</vt:lpstr>
      <vt:lpstr>Prism 7</vt:lpstr>
      <vt:lpstr>GraphPad Prism 9 Project</vt:lpstr>
      <vt:lpstr>Prism 9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 Ponzetti</dc:creator>
  <cp:lastModifiedBy>Marco Ponzetti</cp:lastModifiedBy>
  <cp:revision>179</cp:revision>
  <cp:lastPrinted>2020-07-20T06:27:50Z</cp:lastPrinted>
  <dcterms:created xsi:type="dcterms:W3CDTF">2020-07-09T13:15:25Z</dcterms:created>
  <dcterms:modified xsi:type="dcterms:W3CDTF">2022-01-06T20:28:26Z</dcterms:modified>
</cp:coreProperties>
</file>